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6" r:id="rId5"/>
    <p:sldId id="267" r:id="rId6"/>
    <p:sldId id="268" r:id="rId7"/>
    <p:sldId id="272" r:id="rId8"/>
    <p:sldId id="275" r:id="rId9"/>
    <p:sldId id="276" r:id="rId10"/>
    <p:sldId id="274" r:id="rId11"/>
    <p:sldId id="269" r:id="rId12"/>
    <p:sldId id="270" r:id="rId13"/>
    <p:sldId id="271" r:id="rId14"/>
    <p:sldId id="258" r:id="rId15"/>
    <p:sldId id="259" r:id="rId16"/>
    <p:sldId id="260" r:id="rId17"/>
    <p:sldId id="262" r:id="rId18"/>
    <p:sldId id="263" r:id="rId19"/>
    <p:sldId id="264" r:id="rId20"/>
    <p:sldId id="265" r:id="rId21"/>
    <p:sldId id="257" r:id="rId22"/>
    <p:sldId id="277" r:id="rId23"/>
    <p:sldId id="278" r:id="rId2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BAD72A7-3F95-4759-9279-310176134907}" v="1" dt="2026-01-12T10:47:33.4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8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theme" Target="theme/theme1.xml"/><Relationship Id="rId30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bino Russi" userId="9fa8235e-821d-40bf-9068-111bee6ed44b" providerId="ADAL" clId="{151FE727-A711-4E49-8436-A552277242DA}"/>
    <pc:docChg chg="undo custSel addSld delSld modSld">
      <pc:chgData name="Sabino Russi" userId="9fa8235e-821d-40bf-9068-111bee6ed44b" providerId="ADAL" clId="{151FE727-A711-4E49-8436-A552277242DA}" dt="2026-01-12T10:47:33.492" v="509"/>
      <pc:docMkLst>
        <pc:docMk/>
      </pc:docMkLst>
      <pc:sldChg chg="add">
        <pc:chgData name="Sabino Russi" userId="9fa8235e-821d-40bf-9068-111bee6ed44b" providerId="ADAL" clId="{151FE727-A711-4E49-8436-A552277242DA}" dt="2026-01-12T10:47:33.492" v="509"/>
        <pc:sldMkLst>
          <pc:docMk/>
          <pc:sldMk cId="546389839" sldId="257"/>
        </pc:sldMkLst>
      </pc:sldChg>
      <pc:sldChg chg="add">
        <pc:chgData name="Sabino Russi" userId="9fa8235e-821d-40bf-9068-111bee6ed44b" providerId="ADAL" clId="{151FE727-A711-4E49-8436-A552277242DA}" dt="2026-01-12T10:47:33.492" v="509"/>
        <pc:sldMkLst>
          <pc:docMk/>
          <pc:sldMk cId="1641600384" sldId="277"/>
        </pc:sldMkLst>
      </pc:sldChg>
      <pc:sldChg chg="add">
        <pc:chgData name="Sabino Russi" userId="9fa8235e-821d-40bf-9068-111bee6ed44b" providerId="ADAL" clId="{151FE727-A711-4E49-8436-A552277242DA}" dt="2026-01-12T10:47:33.492" v="509"/>
        <pc:sldMkLst>
          <pc:docMk/>
          <pc:sldMk cId="2465225617" sldId="27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de-DE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6192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4469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842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318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7393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4089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7982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782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4095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5816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8576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de-DE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de-DE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4A8E5F-40E5-4553-9F3C-699F1A5B8145}" type="datetimeFigureOut">
              <a:rPr lang="de-DE" smtClean="0"/>
              <a:t>12.01.2026</a:t>
            </a:fld>
            <a:endParaRPr lang="de-DE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CD45B7-DFE2-4393-8D37-380FC36BF3AA}" type="slidenum">
              <a:rPr lang="de-DE" smtClean="0"/>
              <a:t>‹N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931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4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5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5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5" Type="http://schemas.openxmlformats.org/officeDocument/2006/relationships/image" Target="../media/image68.png"/><Relationship Id="rId4" Type="http://schemas.openxmlformats.org/officeDocument/2006/relationships/image" Target="../media/image67.pn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4" Type="http://schemas.openxmlformats.org/officeDocument/2006/relationships/image" Target="../media/image7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7" Type="http://schemas.openxmlformats.org/officeDocument/2006/relationships/image" Target="../media/image78.png"/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2.png"/><Relationship Id="rId5" Type="http://schemas.openxmlformats.org/officeDocument/2006/relationships/image" Target="../media/image81.png"/><Relationship Id="rId4" Type="http://schemas.openxmlformats.org/officeDocument/2006/relationships/image" Target="../media/image7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3" Type="http://schemas.openxmlformats.org/officeDocument/2006/relationships/image" Target="../media/image73.png"/><Relationship Id="rId7" Type="http://schemas.openxmlformats.org/officeDocument/2006/relationships/image" Target="../media/image87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png"/><Relationship Id="rId5" Type="http://schemas.openxmlformats.org/officeDocument/2006/relationships/image" Target="../media/image85.png"/><Relationship Id="rId4" Type="http://schemas.openxmlformats.org/officeDocument/2006/relationships/image" Target="../media/image84.png"/><Relationship Id="rId9" Type="http://schemas.openxmlformats.org/officeDocument/2006/relationships/image" Target="../media/image7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1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39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D4D4C39-19B5-CC96-13FF-8B64F362C6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 descr="Immagine che contiene nero, bianco e nero, Fotografia monocromatica, neve&#10;&#10;Il contenuto generato dall&amp;#39;IA potrebbe non essere corretto.">
            <a:extLst>
              <a:ext uri="{FF2B5EF4-FFF2-40B4-BE49-F238E27FC236}">
                <a16:creationId xmlns:a16="http://schemas.microsoft.com/office/drawing/2014/main" id="{746BC654-360C-41F3-D287-4614A986D37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149" t="763" r="70" b="170"/>
          <a:stretch>
            <a:fillRect/>
          </a:stretch>
        </p:blipFill>
        <p:spPr>
          <a:xfrm>
            <a:off x="3181749" y="1299663"/>
            <a:ext cx="4940627" cy="1187015"/>
          </a:xfrm>
          <a:prstGeom prst="rect">
            <a:avLst/>
          </a:prstGeom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CDBF9EEF-1559-48E6-23A4-42F29F3CAB29}"/>
              </a:ext>
            </a:extLst>
          </p:cNvPr>
          <p:cNvSpPr txBox="1"/>
          <p:nvPr/>
        </p:nvSpPr>
        <p:spPr>
          <a:xfrm>
            <a:off x="1986298" y="1710168"/>
            <a:ext cx="97592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err="1"/>
              <a:t>mTOR</a:t>
            </a:r>
            <a:r>
              <a:rPr lang="it-IT"/>
              <a:t> </a:t>
            </a:r>
          </a:p>
        </p:txBody>
      </p:sp>
      <p:grpSp>
        <p:nvGrpSpPr>
          <p:cNvPr id="40" name="Gruppo 39">
            <a:extLst>
              <a:ext uri="{FF2B5EF4-FFF2-40B4-BE49-F238E27FC236}">
                <a16:creationId xmlns:a16="http://schemas.microsoft.com/office/drawing/2014/main" id="{F6FE8CA9-C6CB-8FDA-4383-243CE2D9D57E}"/>
              </a:ext>
            </a:extLst>
          </p:cNvPr>
          <p:cNvGrpSpPr/>
          <p:nvPr/>
        </p:nvGrpSpPr>
        <p:grpSpPr>
          <a:xfrm>
            <a:off x="3128071" y="868498"/>
            <a:ext cx="4805037" cy="427654"/>
            <a:chOff x="4441331" y="1284663"/>
            <a:chExt cx="3813520" cy="427654"/>
          </a:xfrm>
        </p:grpSpPr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B6DF09DE-539B-CE62-311B-C1CDFABCFB82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328D3146-5E6F-3F8B-7C0D-A58993A00843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556FC97C-758A-8DD4-9868-C7284A621865}"/>
                </a:ext>
              </a:extLst>
            </p:cNvPr>
            <p:cNvSpPr txBox="1"/>
            <p:nvPr/>
          </p:nvSpPr>
          <p:spPr>
            <a:xfrm>
              <a:off x="5368583" y="1284665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42B9E6F9-14A5-10A6-5DA8-0A1D9D2D2821}"/>
                </a:ext>
              </a:extLst>
            </p:cNvPr>
            <p:cNvSpPr txBox="1"/>
            <p:nvPr/>
          </p:nvSpPr>
          <p:spPr>
            <a:xfrm>
              <a:off x="5845982" y="131220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87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717C1E2F-0259-3C58-D858-5C8FF675E003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92A2CCB0-8CB1-6917-F97E-7A70DCB0409A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290C9E54-EBB8-87C2-4598-8386F75892AA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C0BABD27-72A2-F9DE-A249-277664BB853D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pic>
        <p:nvPicPr>
          <p:cNvPr id="9" name="Immagine 8" descr="Immagine che contiene testo, elettronica, schermata, software&#10;&#10;Il contenuto generato dall&amp;#39;IA potrebbe non essere corretto.">
            <a:extLst>
              <a:ext uri="{FF2B5EF4-FFF2-40B4-BE49-F238E27FC236}">
                <a16:creationId xmlns:a16="http://schemas.microsoft.com/office/drawing/2014/main" id="{A9324CA8-42FE-3BAF-73C8-93E3E06D5AC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0346" t="36011" r="60316" b="27673"/>
          <a:stretch>
            <a:fillRect/>
          </a:stretch>
        </p:blipFill>
        <p:spPr>
          <a:xfrm>
            <a:off x="8320580" y="1298091"/>
            <a:ext cx="1664266" cy="4860666"/>
          </a:xfrm>
          <a:prstGeom prst="rect">
            <a:avLst/>
          </a:prstGeom>
          <a:ln>
            <a:noFill/>
          </a:ln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DBE3700-D3F6-331F-831A-6EE1825CD2F6}"/>
              </a:ext>
            </a:extLst>
          </p:cNvPr>
          <p:cNvSpPr txBox="1"/>
          <p:nvPr/>
        </p:nvSpPr>
        <p:spPr>
          <a:xfrm>
            <a:off x="1989076" y="3944224"/>
            <a:ext cx="98425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GAPDH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677A972-BD7E-B5AD-08A7-3B0D7DF0A40B}"/>
              </a:ext>
            </a:extLst>
          </p:cNvPr>
          <p:cNvSpPr txBox="1"/>
          <p:nvPr/>
        </p:nvSpPr>
        <p:spPr>
          <a:xfrm>
            <a:off x="2070134" y="5061374"/>
            <a:ext cx="939199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LC3A/B</a:t>
            </a:r>
          </a:p>
          <a:p>
            <a:endParaRPr lang="it-IT" dirty="0"/>
          </a:p>
        </p:txBody>
      </p:sp>
      <p:grpSp>
        <p:nvGrpSpPr>
          <p:cNvPr id="17" name="Gruppo 16">
            <a:extLst>
              <a:ext uri="{FF2B5EF4-FFF2-40B4-BE49-F238E27FC236}">
                <a16:creationId xmlns:a16="http://schemas.microsoft.com/office/drawing/2014/main" id="{6943ACA4-57E9-3181-A786-1658953364DC}"/>
              </a:ext>
            </a:extLst>
          </p:cNvPr>
          <p:cNvGrpSpPr/>
          <p:nvPr/>
        </p:nvGrpSpPr>
        <p:grpSpPr>
          <a:xfrm>
            <a:off x="3124495" y="3811761"/>
            <a:ext cx="5056608" cy="2101864"/>
            <a:chOff x="2161781" y="4440411"/>
            <a:chExt cx="5056608" cy="2101864"/>
          </a:xfrm>
        </p:grpSpPr>
        <p:pic>
          <p:nvPicPr>
            <p:cNvPr id="2" name="Immagine 1" descr="Immagine che contiene bianco e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124A3B5C-2B78-0021-EAA4-C4F589770CD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136" t="9549" r="1594" b="2759"/>
            <a:stretch>
              <a:fillRect/>
            </a:stretch>
          </p:blipFill>
          <p:spPr>
            <a:xfrm>
              <a:off x="2161781" y="4440411"/>
              <a:ext cx="5041459" cy="2101864"/>
            </a:xfrm>
            <a:prstGeom prst="rect">
              <a:avLst/>
            </a:prstGeom>
          </p:spPr>
        </p:pic>
        <p:pic>
          <p:nvPicPr>
            <p:cNvPr id="10" name="Immagine 9" descr="Immagine che contiene nero, bianco e nero, intern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9CB177B7-6105-7DE9-C66B-E96130459D4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5628" t="9231" r="2269" b="64231"/>
            <a:stretch>
              <a:fillRect/>
            </a:stretch>
          </p:blipFill>
          <p:spPr>
            <a:xfrm>
              <a:off x="2162576" y="4441750"/>
              <a:ext cx="5055813" cy="641131"/>
            </a:xfrm>
            <a:prstGeom prst="rect">
              <a:avLst/>
            </a:prstGeom>
          </p:spPr>
        </p:pic>
      </p:grp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4AB9BBE3-3F2E-CC79-831A-A22842C1561E}"/>
              </a:ext>
            </a:extLst>
          </p:cNvPr>
          <p:cNvSpPr txBox="1"/>
          <p:nvPr/>
        </p:nvSpPr>
        <p:spPr>
          <a:xfrm>
            <a:off x="9594840" y="5232710"/>
            <a:ext cx="2054646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>
                <a:solidFill>
                  <a:srgbClr val="1C2721"/>
                </a:solidFill>
                <a:latin typeface="Aptos"/>
              </a:rPr>
              <a:t>Precision Plus Protein™ Kaleidoscope™ </a:t>
            </a:r>
            <a:r>
              <a:rPr lang="en-US" sz="1200" err="1">
                <a:solidFill>
                  <a:srgbClr val="1C2721"/>
                </a:solidFill>
                <a:latin typeface="Aptos"/>
              </a:rPr>
              <a:t>Prestained</a:t>
            </a:r>
            <a:r>
              <a:rPr lang="en-US" sz="1200">
                <a:solidFill>
                  <a:srgbClr val="1C2721"/>
                </a:solidFill>
                <a:latin typeface="Aptos"/>
              </a:rPr>
              <a:t> Protein Standards</a:t>
            </a:r>
          </a:p>
        </p:txBody>
      </p:sp>
      <p:pic>
        <p:nvPicPr>
          <p:cNvPr id="18" name="Immagine 17" descr="Immagine che contiene testo, schermata, software, Software multimediale&#10;&#10;Il contenuto generato dall&amp;#39;IA potrebbe non essere corretto.">
            <a:extLst>
              <a:ext uri="{FF2B5EF4-FFF2-40B4-BE49-F238E27FC236}">
                <a16:creationId xmlns:a16="http://schemas.microsoft.com/office/drawing/2014/main" id="{4DA5A31E-052A-09A3-F64C-675959F0923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2575" t="36787" r="52619" b="54602"/>
          <a:stretch>
            <a:fillRect/>
          </a:stretch>
        </p:blipFill>
        <p:spPr>
          <a:xfrm>
            <a:off x="3166088" y="3225395"/>
            <a:ext cx="4941294" cy="590564"/>
          </a:xfrm>
          <a:prstGeom prst="rect">
            <a:avLst/>
          </a:prstGeom>
        </p:spPr>
      </p:pic>
      <p:pic>
        <p:nvPicPr>
          <p:cNvPr id="3" name="Immagine 2" descr="Immagine che contiene schermata, bianco e nero, Rettangolo, nero&#10;&#10;Il contenuto generato dall&amp;#39;IA potrebbe non essere corretto.">
            <a:extLst>
              <a:ext uri="{FF2B5EF4-FFF2-40B4-BE49-F238E27FC236}">
                <a16:creationId xmlns:a16="http://schemas.microsoft.com/office/drawing/2014/main" id="{89B8B9D4-5723-76DF-90F9-258C47A9C5C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-38" t="28658" r="182" b="-610"/>
          <a:stretch>
            <a:fillRect/>
          </a:stretch>
        </p:blipFill>
        <p:spPr>
          <a:xfrm>
            <a:off x="3163050" y="2491769"/>
            <a:ext cx="4939504" cy="894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60458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>
            <a:extLst>
              <a:ext uri="{FF2B5EF4-FFF2-40B4-BE49-F238E27FC236}">
                <a16:creationId xmlns:a16="http://schemas.microsoft.com/office/drawing/2014/main" id="{C1C06F8F-3FB5-177C-2704-0530EF86608C}"/>
              </a:ext>
            </a:extLst>
          </p:cNvPr>
          <p:cNvSpPr txBox="1"/>
          <p:nvPr/>
        </p:nvSpPr>
        <p:spPr>
          <a:xfrm>
            <a:off x="6937693" y="4478960"/>
            <a:ext cx="96398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LC3A/B </a:t>
            </a:r>
          </a:p>
        </p:txBody>
      </p:sp>
      <p:grpSp>
        <p:nvGrpSpPr>
          <p:cNvPr id="8" name="Gruppo 7">
            <a:extLst>
              <a:ext uri="{FF2B5EF4-FFF2-40B4-BE49-F238E27FC236}">
                <a16:creationId xmlns:a16="http://schemas.microsoft.com/office/drawing/2014/main" id="{712B16BC-EA96-27FC-2FBC-543A11258CA1}"/>
              </a:ext>
            </a:extLst>
          </p:cNvPr>
          <p:cNvGrpSpPr/>
          <p:nvPr/>
        </p:nvGrpSpPr>
        <p:grpSpPr>
          <a:xfrm>
            <a:off x="5184598" y="1823964"/>
            <a:ext cx="1540406" cy="3272844"/>
            <a:chOff x="5898973" y="1795389"/>
            <a:chExt cx="1540406" cy="3272844"/>
          </a:xfrm>
        </p:grpSpPr>
        <p:pic>
          <p:nvPicPr>
            <p:cNvPr id="3" name="Immagine 2" descr="Immagine che contiene testo, elettronica, schermata, software&#10;&#10;Il contenuto generato dall&amp;#39;IA potrebbe non essere corretto.">
              <a:extLst>
                <a:ext uri="{FF2B5EF4-FFF2-40B4-BE49-F238E27FC236}">
                  <a16:creationId xmlns:a16="http://schemas.microsoft.com/office/drawing/2014/main" id="{52A62339-C26C-BC7E-4FA3-A924B1D2C06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362" t="29861" r="64113" b="50286"/>
            <a:stretch>
              <a:fillRect/>
            </a:stretch>
          </p:blipFill>
          <p:spPr>
            <a:xfrm>
              <a:off x="5906453" y="3348124"/>
              <a:ext cx="1532926" cy="17201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Immagine 9" descr="Immagine che contiene testo, schermata, software, Software multimediale&#10;&#10;Il contenuto generato dall&amp;#39;IA potrebbe non essere corretto.">
              <a:extLst>
                <a:ext uri="{FF2B5EF4-FFF2-40B4-BE49-F238E27FC236}">
                  <a16:creationId xmlns:a16="http://schemas.microsoft.com/office/drawing/2014/main" id="{C6546BB0-F35C-5C7A-3762-3C49FEA49D9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2155" t="27309" r="66315" b="49994"/>
            <a:stretch>
              <a:fillRect/>
            </a:stretch>
          </p:blipFill>
          <p:spPr>
            <a:xfrm>
              <a:off x="5898973" y="1892929"/>
              <a:ext cx="1533497" cy="18195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Immagine 19" descr="Immagine che contiene testo, schermata, software, Software multimediale&#10;&#10;Il contenuto generato dall&amp;#39;IA potrebbe non essere corretto.">
              <a:extLst>
                <a:ext uri="{FF2B5EF4-FFF2-40B4-BE49-F238E27FC236}">
                  <a16:creationId xmlns:a16="http://schemas.microsoft.com/office/drawing/2014/main" id="{C3DFC8AD-C5F8-DCCF-449A-1D5EE786FC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2938" t="32920" r="65075" b="58902"/>
            <a:stretch>
              <a:fillRect/>
            </a:stretch>
          </p:blipFill>
          <p:spPr>
            <a:xfrm>
              <a:off x="5901827" y="1795389"/>
              <a:ext cx="1515949" cy="7309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C9237E20-0E59-80B6-DA9D-A282E1D1CB20}"/>
              </a:ext>
            </a:extLst>
          </p:cNvPr>
          <p:cNvSpPr txBox="1"/>
          <p:nvPr/>
        </p:nvSpPr>
        <p:spPr>
          <a:xfrm>
            <a:off x="6919334" y="2183780"/>
            <a:ext cx="755585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PARP </a:t>
            </a:r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9CC4460E-2FE8-4F93-AA0A-D47829305BB7}"/>
              </a:ext>
            </a:extLst>
          </p:cNvPr>
          <p:cNvGrpSpPr/>
          <p:nvPr/>
        </p:nvGrpSpPr>
        <p:grpSpPr>
          <a:xfrm>
            <a:off x="2710293" y="1754547"/>
            <a:ext cx="2478548" cy="3433599"/>
            <a:chOff x="872427" y="1725972"/>
            <a:chExt cx="2478548" cy="3433599"/>
          </a:xfrm>
        </p:grpSpPr>
        <p:pic>
          <p:nvPicPr>
            <p:cNvPr id="12" name="Immagine 11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5F05D663-01F1-EF46-FD43-9DB97998DC3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C4DCA5F4-2CD5-5205-CF6E-C55F1285F170}"/>
                </a:ext>
              </a:extLst>
            </p:cNvPr>
            <p:cNvSpPr txBox="1"/>
            <p:nvPr/>
          </p:nvSpPr>
          <p:spPr>
            <a:xfrm>
              <a:off x="872427" y="4559407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/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>
                  <a:solidFill>
                    <a:srgbClr val="333333"/>
                  </a:solidFill>
                  <a:latin typeface="Aptos"/>
                </a:rPr>
                <a:t>, </a:t>
              </a:r>
              <a:endParaRPr lang="en-US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/>
            </a:p>
          </p:txBody>
        </p:sp>
      </p:grp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E8A2617-8F11-7C2A-6ACE-3FEC22164A4C}"/>
              </a:ext>
            </a:extLst>
          </p:cNvPr>
          <p:cNvSpPr txBox="1"/>
          <p:nvPr/>
        </p:nvSpPr>
        <p:spPr>
          <a:xfrm>
            <a:off x="5947926" y="1234144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D20481B-AE2D-AECD-4A5C-05CADAABD038}"/>
              </a:ext>
            </a:extLst>
          </p:cNvPr>
          <p:cNvSpPr txBox="1"/>
          <p:nvPr/>
        </p:nvSpPr>
        <p:spPr>
          <a:xfrm>
            <a:off x="5261572" y="1244170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945BE71-D8F6-B677-3199-43ECFEC79D5E}"/>
              </a:ext>
            </a:extLst>
          </p:cNvPr>
          <p:cNvSpPr txBox="1"/>
          <p:nvPr/>
        </p:nvSpPr>
        <p:spPr>
          <a:xfrm>
            <a:off x="6939076" y="3007367"/>
            <a:ext cx="913905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it-IT" dirty="0" err="1"/>
              <a:t>Tubulin</a:t>
            </a:r>
            <a:endParaRPr lang="en-US" dirty="0" err="1"/>
          </a:p>
        </p:txBody>
      </p:sp>
    </p:spTree>
    <p:extLst>
      <p:ext uri="{BB962C8B-B14F-4D97-AF65-F5344CB8AC3E}">
        <p14:creationId xmlns:p14="http://schemas.microsoft.com/office/powerpoint/2010/main" val="15051005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AAA2B2C3-58F7-E62F-7F02-31A1C3A34AB2}"/>
              </a:ext>
            </a:extLst>
          </p:cNvPr>
          <p:cNvGrpSpPr/>
          <p:nvPr/>
        </p:nvGrpSpPr>
        <p:grpSpPr>
          <a:xfrm>
            <a:off x="4328984" y="1408405"/>
            <a:ext cx="3534031" cy="4459846"/>
            <a:chOff x="395288" y="2005013"/>
            <a:chExt cx="4195767" cy="445984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847A740-BBAA-EA98-330A-06924226873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-9" t="-270" r="9" b="12829"/>
            <a:stretch>
              <a:fillRect/>
            </a:stretch>
          </p:blipFill>
          <p:spPr>
            <a:xfrm>
              <a:off x="519113" y="2005013"/>
              <a:ext cx="4067179" cy="142422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CD53D6F-F71D-A51C-3FCD-D2C195DF5E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-108" t="310" r="2810"/>
            <a:stretch>
              <a:fillRect/>
            </a:stretch>
          </p:blipFill>
          <p:spPr>
            <a:xfrm>
              <a:off x="519470" y="3428643"/>
              <a:ext cx="4071585" cy="141482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599349B-A7ED-8556-BA01-F30E753589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-521" t="10353" r="8"/>
            <a:stretch>
              <a:fillRect/>
            </a:stretch>
          </p:blipFill>
          <p:spPr>
            <a:xfrm>
              <a:off x="395288" y="4843463"/>
              <a:ext cx="4193978" cy="1621396"/>
            </a:xfrm>
            <a:prstGeom prst="rect">
              <a:avLst/>
            </a:prstGeom>
          </p:spPr>
        </p:pic>
      </p:grpSp>
      <p:grpSp>
        <p:nvGrpSpPr>
          <p:cNvPr id="12" name="Gruppo 11">
            <a:extLst>
              <a:ext uri="{FF2B5EF4-FFF2-40B4-BE49-F238E27FC236}">
                <a16:creationId xmlns:a16="http://schemas.microsoft.com/office/drawing/2014/main" id="{728EF1AB-4E28-F7C3-6E98-7876AC698815}"/>
              </a:ext>
            </a:extLst>
          </p:cNvPr>
          <p:cNvGrpSpPr/>
          <p:nvPr/>
        </p:nvGrpSpPr>
        <p:grpSpPr>
          <a:xfrm>
            <a:off x="1788755" y="1665772"/>
            <a:ext cx="2423394" cy="4302496"/>
            <a:chOff x="927581" y="1725972"/>
            <a:chExt cx="2423394" cy="3631207"/>
          </a:xfrm>
        </p:grpSpPr>
        <p:pic>
          <p:nvPicPr>
            <p:cNvPr id="9" name="Immagine 8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B3F1A9AC-43A5-2096-D6F5-D2E01E6888D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CF75BE4C-AB3C-396D-306B-F773137F958B}"/>
                </a:ext>
              </a:extLst>
            </p:cNvPr>
            <p:cNvSpPr txBox="1"/>
            <p:nvPr/>
          </p:nvSpPr>
          <p:spPr>
            <a:xfrm>
              <a:off x="927581" y="4757015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 dirty="0"/>
            </a:p>
            <a:p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dirty="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, </a:t>
              </a:r>
              <a:endParaRPr lang="en-US" dirty="0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 dirty="0"/>
            </a:p>
          </p:txBody>
        </p:sp>
      </p:grp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1199B16D-9EF8-0FC7-6F2A-2A3B175EE762}"/>
              </a:ext>
            </a:extLst>
          </p:cNvPr>
          <p:cNvSpPr txBox="1"/>
          <p:nvPr/>
        </p:nvSpPr>
        <p:spPr>
          <a:xfrm>
            <a:off x="7967657" y="1932680"/>
            <a:ext cx="274319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Vinculin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AB513AF-4A9C-0727-C2C5-4E6F6B654C8C}"/>
              </a:ext>
            </a:extLst>
          </p:cNvPr>
          <p:cNvSpPr txBox="1"/>
          <p:nvPr/>
        </p:nvSpPr>
        <p:spPr>
          <a:xfrm>
            <a:off x="7967657" y="5072488"/>
            <a:ext cx="274319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LC3A/B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65B48814-0AA0-3647-A0BE-B410DE68A3B3}"/>
              </a:ext>
            </a:extLst>
          </p:cNvPr>
          <p:cNvSpPr txBox="1"/>
          <p:nvPr/>
        </p:nvSpPr>
        <p:spPr>
          <a:xfrm>
            <a:off x="6645629" y="969907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NCI-N87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04AE36A-16EB-20B8-095F-67195679F867}"/>
              </a:ext>
            </a:extLst>
          </p:cNvPr>
          <p:cNvSpPr txBox="1"/>
          <p:nvPr/>
        </p:nvSpPr>
        <p:spPr>
          <a:xfrm>
            <a:off x="5989354" y="95988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NCI-N87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89FCB3B6-6C4F-3DAD-FEB3-F8977EF31ACF}"/>
              </a:ext>
            </a:extLst>
          </p:cNvPr>
          <p:cNvSpPr txBox="1"/>
          <p:nvPr/>
        </p:nvSpPr>
        <p:spPr>
          <a:xfrm>
            <a:off x="5322156" y="95988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AGS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A80B67CF-BC61-B439-3F02-C74E30C071F5}"/>
              </a:ext>
            </a:extLst>
          </p:cNvPr>
          <p:cNvSpPr txBox="1"/>
          <p:nvPr/>
        </p:nvSpPr>
        <p:spPr>
          <a:xfrm>
            <a:off x="4786197" y="969907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AGS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654B3187-3EB0-A6D9-B317-82884B8FA0E3}"/>
              </a:ext>
            </a:extLst>
          </p:cNvPr>
          <p:cNvSpPr txBox="1"/>
          <p:nvPr/>
        </p:nvSpPr>
        <p:spPr>
          <a:xfrm>
            <a:off x="7971885" y="3056861"/>
            <a:ext cx="150551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SQSTM1/p62</a:t>
            </a:r>
          </a:p>
        </p:txBody>
      </p:sp>
    </p:spTree>
    <p:extLst>
      <p:ext uri="{BB962C8B-B14F-4D97-AF65-F5344CB8AC3E}">
        <p14:creationId xmlns:p14="http://schemas.microsoft.com/office/powerpoint/2010/main" val="21979048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>
            <a:extLst>
              <a:ext uri="{FF2B5EF4-FFF2-40B4-BE49-F238E27FC236}">
                <a16:creationId xmlns:a16="http://schemas.microsoft.com/office/drawing/2014/main" id="{18990EEA-2412-EEE5-FF67-113AB81D067C}"/>
              </a:ext>
            </a:extLst>
          </p:cNvPr>
          <p:cNvGrpSpPr/>
          <p:nvPr/>
        </p:nvGrpSpPr>
        <p:grpSpPr>
          <a:xfrm>
            <a:off x="4438271" y="1036499"/>
            <a:ext cx="3619626" cy="5032630"/>
            <a:chOff x="3009521" y="1712194"/>
            <a:chExt cx="3619626" cy="503263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B3C808B-C1A9-D1D1-A5C7-0A2315C77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09521" y="1712194"/>
              <a:ext cx="3569494" cy="207720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E1CABE32-6B15-C474-D65E-66FE038CD83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5496" r="5822" b="-585"/>
            <a:stretch>
              <a:fillRect/>
            </a:stretch>
          </p:blipFill>
          <p:spPr>
            <a:xfrm>
              <a:off x="3052474" y="4364314"/>
              <a:ext cx="3576673" cy="238051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811D79B-97EC-E799-412B-0871CA8E337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-451" t="-10870" r="7070" b="32609"/>
            <a:stretch>
              <a:fillRect/>
            </a:stretch>
          </p:blipFill>
          <p:spPr>
            <a:xfrm>
              <a:off x="3012368" y="3618949"/>
              <a:ext cx="3562474" cy="1083089"/>
            </a:xfrm>
            <a:prstGeom prst="rect">
              <a:avLst/>
            </a:prstGeom>
          </p:spPr>
        </p:pic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52EE81DF-E46E-EC91-45C1-2F6D7E3A7E72}"/>
              </a:ext>
            </a:extLst>
          </p:cNvPr>
          <p:cNvGrpSpPr/>
          <p:nvPr/>
        </p:nvGrpSpPr>
        <p:grpSpPr>
          <a:xfrm>
            <a:off x="1585500" y="1140514"/>
            <a:ext cx="2788704" cy="4953675"/>
            <a:chOff x="562271" y="1725972"/>
            <a:chExt cx="2788704" cy="3433599"/>
          </a:xfrm>
        </p:grpSpPr>
        <p:pic>
          <p:nvPicPr>
            <p:cNvPr id="3" name="Immagine 2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D9DAEF0F-806E-7F42-F1D6-6602EF8701A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014DF0DE-5A10-2174-309D-9EEEF91685CC}"/>
                </a:ext>
              </a:extLst>
            </p:cNvPr>
            <p:cNvSpPr txBox="1"/>
            <p:nvPr/>
          </p:nvSpPr>
          <p:spPr>
            <a:xfrm>
              <a:off x="562271" y="4441541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/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>
                  <a:solidFill>
                    <a:srgbClr val="333333"/>
                  </a:solidFill>
                  <a:latin typeface="Aptos"/>
                </a:rPr>
                <a:t>, </a:t>
              </a:r>
              <a:endParaRPr lang="en-US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/>
            </a:p>
          </p:txBody>
        </p:sp>
      </p:grp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0AABC6D-30FC-4523-140D-F407684D4CAE}"/>
              </a:ext>
            </a:extLst>
          </p:cNvPr>
          <p:cNvSpPr txBox="1"/>
          <p:nvPr/>
        </p:nvSpPr>
        <p:spPr>
          <a:xfrm>
            <a:off x="6757551" y="600057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NCI-N87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13C20F2-9EE4-E527-D4C7-80301C17F739}"/>
              </a:ext>
            </a:extLst>
          </p:cNvPr>
          <p:cNvSpPr txBox="1"/>
          <p:nvPr/>
        </p:nvSpPr>
        <p:spPr>
          <a:xfrm>
            <a:off x="6101276" y="59003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NCI-N87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B62BB13-D0C6-8030-8FB6-F14A39D086DC}"/>
              </a:ext>
            </a:extLst>
          </p:cNvPr>
          <p:cNvSpPr txBox="1"/>
          <p:nvPr/>
        </p:nvSpPr>
        <p:spPr>
          <a:xfrm>
            <a:off x="5434078" y="59003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AGS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F330AAD9-28B6-857E-744D-45416B4CB6E7}"/>
              </a:ext>
            </a:extLst>
          </p:cNvPr>
          <p:cNvSpPr txBox="1"/>
          <p:nvPr/>
        </p:nvSpPr>
        <p:spPr>
          <a:xfrm>
            <a:off x="4898119" y="600057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AGS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55929DF-AD1C-7783-0FDA-D16F27B78622}"/>
              </a:ext>
            </a:extLst>
          </p:cNvPr>
          <p:cNvSpPr txBox="1"/>
          <p:nvPr/>
        </p:nvSpPr>
        <p:spPr>
          <a:xfrm>
            <a:off x="8116302" y="1941173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PARP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22FC4BD2-E3B1-BB91-776E-A9566F4556B3}"/>
              </a:ext>
            </a:extLst>
          </p:cNvPr>
          <p:cNvSpPr txBox="1"/>
          <p:nvPr/>
        </p:nvSpPr>
        <p:spPr>
          <a:xfrm>
            <a:off x="8116301" y="3615567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Actin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AC22F797-E42B-02DE-34CC-92B20AF0A5F6}"/>
              </a:ext>
            </a:extLst>
          </p:cNvPr>
          <p:cNvSpPr txBox="1"/>
          <p:nvPr/>
        </p:nvSpPr>
        <p:spPr>
          <a:xfrm>
            <a:off x="8056143" y="4177041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CASP3</a:t>
            </a:r>
          </a:p>
        </p:txBody>
      </p:sp>
    </p:spTree>
    <p:extLst>
      <p:ext uri="{BB962C8B-B14F-4D97-AF65-F5344CB8AC3E}">
        <p14:creationId xmlns:p14="http://schemas.microsoft.com/office/powerpoint/2010/main" val="40130690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po 22">
            <a:extLst>
              <a:ext uri="{FF2B5EF4-FFF2-40B4-BE49-F238E27FC236}">
                <a16:creationId xmlns:a16="http://schemas.microsoft.com/office/drawing/2014/main" id="{759A5DC6-896E-CDB9-2A5C-6A53FAF5E5AB}"/>
              </a:ext>
            </a:extLst>
          </p:cNvPr>
          <p:cNvGrpSpPr/>
          <p:nvPr/>
        </p:nvGrpSpPr>
        <p:grpSpPr>
          <a:xfrm>
            <a:off x="3933333" y="1577546"/>
            <a:ext cx="3771089" cy="4620495"/>
            <a:chOff x="4013543" y="1226625"/>
            <a:chExt cx="3670827" cy="497141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EF5837D-E1C3-0BD6-9E15-BA3534D0D9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13828" y="1226625"/>
              <a:ext cx="3670263" cy="2406389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16BADB5-6331-3619-179B-ED391E911F3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-9600" r="1613" b="-4400"/>
            <a:stretch>
              <a:fillRect/>
            </a:stretch>
          </p:blipFill>
          <p:spPr>
            <a:xfrm>
              <a:off x="4013543" y="3340300"/>
              <a:ext cx="3670827" cy="2857741"/>
            </a:xfrm>
            <a:prstGeom prst="rect">
              <a:avLst/>
            </a:prstGeom>
          </p:spPr>
        </p:pic>
      </p:grpSp>
      <p:grpSp>
        <p:nvGrpSpPr>
          <p:cNvPr id="10" name="Gruppo 9">
            <a:extLst>
              <a:ext uri="{FF2B5EF4-FFF2-40B4-BE49-F238E27FC236}">
                <a16:creationId xmlns:a16="http://schemas.microsoft.com/office/drawing/2014/main" id="{C77481B4-D566-176F-2094-577E56B4587C}"/>
              </a:ext>
            </a:extLst>
          </p:cNvPr>
          <p:cNvGrpSpPr/>
          <p:nvPr/>
        </p:nvGrpSpPr>
        <p:grpSpPr>
          <a:xfrm>
            <a:off x="1149355" y="1886393"/>
            <a:ext cx="2788704" cy="4311990"/>
            <a:chOff x="562271" y="1725972"/>
            <a:chExt cx="2788704" cy="3433599"/>
          </a:xfrm>
        </p:grpSpPr>
        <p:pic>
          <p:nvPicPr>
            <p:cNvPr id="3" name="Immagine 2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C20DA29C-FD3C-74DC-2FC7-9E94E45215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552C8F3F-137E-C796-54A2-E7565F7DE555}"/>
                </a:ext>
              </a:extLst>
            </p:cNvPr>
            <p:cNvSpPr txBox="1"/>
            <p:nvPr/>
          </p:nvSpPr>
          <p:spPr>
            <a:xfrm>
              <a:off x="562271" y="4441541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/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>
                  <a:solidFill>
                    <a:srgbClr val="333333"/>
                  </a:solidFill>
                  <a:latin typeface="Aptos"/>
                </a:rPr>
                <a:t>, </a:t>
              </a:r>
              <a:endParaRPr lang="en-US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/>
            </a:p>
          </p:txBody>
        </p:sp>
      </p:grp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8D5E930-D574-66A2-32D9-1EF5CFA266DC}"/>
              </a:ext>
            </a:extLst>
          </p:cNvPr>
          <p:cNvSpPr txBox="1"/>
          <p:nvPr/>
        </p:nvSpPr>
        <p:spPr>
          <a:xfrm>
            <a:off x="6592117" y="103512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B037C0B3-8165-9B02-D86D-EEA9531E4665}"/>
              </a:ext>
            </a:extLst>
          </p:cNvPr>
          <p:cNvSpPr txBox="1"/>
          <p:nvPr/>
        </p:nvSpPr>
        <p:spPr>
          <a:xfrm>
            <a:off x="5875684" y="1025095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 err="1"/>
              <a:t>Vehicle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7EE0CC9-BA62-9183-E15B-861AE16DD2D2}"/>
              </a:ext>
            </a:extLst>
          </p:cNvPr>
          <p:cNvSpPr txBox="1"/>
          <p:nvPr/>
        </p:nvSpPr>
        <p:spPr>
          <a:xfrm>
            <a:off x="5098196" y="1025095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04E3CE7D-E485-32B1-8A3A-5B20BEB9EF3B}"/>
              </a:ext>
            </a:extLst>
          </p:cNvPr>
          <p:cNvSpPr txBox="1"/>
          <p:nvPr/>
        </p:nvSpPr>
        <p:spPr>
          <a:xfrm>
            <a:off x="4411842" y="103512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AEFA9F81-428A-9A08-2BE3-3E9334D20326}"/>
              </a:ext>
            </a:extLst>
          </p:cNvPr>
          <p:cNvSpPr txBox="1"/>
          <p:nvPr/>
        </p:nvSpPr>
        <p:spPr>
          <a:xfrm>
            <a:off x="7790447" y="2486527"/>
            <a:ext cx="11028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PARP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E6848224-AA55-9A4A-B765-2FB71BC18130}"/>
              </a:ext>
            </a:extLst>
          </p:cNvPr>
          <p:cNvSpPr txBox="1"/>
          <p:nvPr/>
        </p:nvSpPr>
        <p:spPr>
          <a:xfrm>
            <a:off x="7790447" y="3559342"/>
            <a:ext cx="11028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Tubulina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16166226-3B4F-E157-7B92-4009A5DD34C1}"/>
              </a:ext>
            </a:extLst>
          </p:cNvPr>
          <p:cNvSpPr txBox="1"/>
          <p:nvPr/>
        </p:nvSpPr>
        <p:spPr>
          <a:xfrm>
            <a:off x="7850604" y="4070684"/>
            <a:ext cx="11028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CASP3</a:t>
            </a:r>
          </a:p>
        </p:txBody>
      </p:sp>
    </p:spTree>
    <p:extLst>
      <p:ext uri="{BB962C8B-B14F-4D97-AF65-F5344CB8AC3E}">
        <p14:creationId xmlns:p14="http://schemas.microsoft.com/office/powerpoint/2010/main" val="191290068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o 14">
            <a:extLst>
              <a:ext uri="{FF2B5EF4-FFF2-40B4-BE49-F238E27FC236}">
                <a16:creationId xmlns:a16="http://schemas.microsoft.com/office/drawing/2014/main" id="{8CD7A75F-1E66-C70E-479F-603D2F71D0B7}"/>
              </a:ext>
            </a:extLst>
          </p:cNvPr>
          <p:cNvGrpSpPr/>
          <p:nvPr/>
        </p:nvGrpSpPr>
        <p:grpSpPr>
          <a:xfrm>
            <a:off x="1069144" y="843657"/>
            <a:ext cx="2598204" cy="5775831"/>
            <a:chOff x="562271" y="1725972"/>
            <a:chExt cx="2788704" cy="3433599"/>
          </a:xfrm>
        </p:grpSpPr>
        <p:pic>
          <p:nvPicPr>
            <p:cNvPr id="3" name="Immagine 2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9A9B6371-B060-4C41-85BD-03CA8AA542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59D30D99-A7E4-9494-56F1-15CCF364F282}"/>
                </a:ext>
              </a:extLst>
            </p:cNvPr>
            <p:cNvSpPr txBox="1"/>
            <p:nvPr/>
          </p:nvSpPr>
          <p:spPr>
            <a:xfrm>
              <a:off x="562271" y="4441541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/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>
                  <a:solidFill>
                    <a:srgbClr val="333333"/>
                  </a:solidFill>
                  <a:latin typeface="Aptos"/>
                </a:rPr>
                <a:t>, </a:t>
              </a:r>
              <a:endParaRPr lang="en-US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/>
            </a:p>
          </p:txBody>
        </p:sp>
      </p:grpSp>
      <p:grpSp>
        <p:nvGrpSpPr>
          <p:cNvPr id="19" name="Gruppo 18">
            <a:extLst>
              <a:ext uri="{FF2B5EF4-FFF2-40B4-BE49-F238E27FC236}">
                <a16:creationId xmlns:a16="http://schemas.microsoft.com/office/drawing/2014/main" id="{CB72D1F4-BC6E-90E2-358B-2B62A70084ED}"/>
              </a:ext>
            </a:extLst>
          </p:cNvPr>
          <p:cNvGrpSpPr/>
          <p:nvPr/>
        </p:nvGrpSpPr>
        <p:grpSpPr>
          <a:xfrm>
            <a:off x="3682866" y="962218"/>
            <a:ext cx="5820620" cy="5389178"/>
            <a:chOff x="3682866" y="962218"/>
            <a:chExt cx="5820620" cy="5389178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88EBBC7-9E89-C63B-6713-3C0665C9A56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361" b="8383"/>
            <a:stretch>
              <a:fillRect/>
            </a:stretch>
          </p:blipFill>
          <p:spPr>
            <a:xfrm>
              <a:off x="3687863" y="962218"/>
              <a:ext cx="5806412" cy="165687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4209AEC-0014-43BE-770E-1E2D8CED4A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92893" y="3184914"/>
              <a:ext cx="5796353" cy="1153527"/>
            </a:xfrm>
            <a:prstGeom prst="rect">
              <a:avLst/>
            </a:prstGeom>
          </p:spPr>
        </p:pic>
        <p:pic>
          <p:nvPicPr>
            <p:cNvPr id="16" name="Immagine 15" descr="Immagine che contiene nero, schermata, Fotografia monocromatica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EA283395-46E2-5796-D156-B43678FB740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3059" t="21801" r="2118" b="474"/>
            <a:stretch>
              <a:fillRect/>
            </a:stretch>
          </p:blipFill>
          <p:spPr>
            <a:xfrm>
              <a:off x="3696040" y="4707856"/>
              <a:ext cx="5807446" cy="1643540"/>
            </a:xfrm>
            <a:prstGeom prst="rect">
              <a:avLst/>
            </a:prstGeom>
          </p:spPr>
        </p:pic>
        <p:pic>
          <p:nvPicPr>
            <p:cNvPr id="18" name="Picture 10" descr="Immagine che contiene nero, bianco, bianco e ner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7BC46B7F-CB18-D4BC-53BE-0E5A61ADE4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-256" r="-173" b="54867"/>
            <a:stretch>
              <a:fillRect/>
            </a:stretch>
          </p:blipFill>
          <p:spPr>
            <a:xfrm>
              <a:off x="3682866" y="4154565"/>
              <a:ext cx="5806404" cy="514472"/>
            </a:xfrm>
            <a:prstGeom prst="rect">
              <a:avLst/>
            </a:prstGeom>
          </p:spPr>
        </p:pic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DA194F46-526C-3F74-6950-98F21DF15568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-286" t="16997" r="1980" b="-833"/>
          <a:stretch>
            <a:fillRect/>
          </a:stretch>
        </p:blipFill>
        <p:spPr>
          <a:xfrm>
            <a:off x="3686014" y="2720802"/>
            <a:ext cx="5805483" cy="1006162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42E715BF-BA95-B9C4-4F6E-76EADAEA27FB}"/>
              </a:ext>
            </a:extLst>
          </p:cNvPr>
          <p:cNvSpPr txBox="1"/>
          <p:nvPr/>
        </p:nvSpPr>
        <p:spPr>
          <a:xfrm>
            <a:off x="6588106" y="559873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C237AE6A-584C-16DA-F989-79B9A6B32701}"/>
              </a:ext>
            </a:extLst>
          </p:cNvPr>
          <p:cNvSpPr txBox="1"/>
          <p:nvPr/>
        </p:nvSpPr>
        <p:spPr>
          <a:xfrm>
            <a:off x="7566120" y="519768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 err="1"/>
              <a:t>Vehicle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40F78427-A0F4-57AA-E1EE-D32745B55A70}"/>
              </a:ext>
            </a:extLst>
          </p:cNvPr>
          <p:cNvSpPr txBox="1"/>
          <p:nvPr/>
        </p:nvSpPr>
        <p:spPr>
          <a:xfrm>
            <a:off x="8284559" y="561879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17D37C98-24FD-79CC-D023-2225785472FE}"/>
              </a:ext>
            </a:extLst>
          </p:cNvPr>
          <p:cNvSpPr txBox="1"/>
          <p:nvPr/>
        </p:nvSpPr>
        <p:spPr>
          <a:xfrm>
            <a:off x="5723284" y="521773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 err="1"/>
              <a:t>Vehicle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0E4FF35F-7CFD-C144-9E2D-97A4A82A472C}"/>
              </a:ext>
            </a:extLst>
          </p:cNvPr>
          <p:cNvSpPr txBox="1"/>
          <p:nvPr/>
        </p:nvSpPr>
        <p:spPr>
          <a:xfrm>
            <a:off x="4887643" y="563884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F0B44768-5E01-1470-8D33-E3EA3FE73709}"/>
              </a:ext>
            </a:extLst>
          </p:cNvPr>
          <p:cNvSpPr txBox="1"/>
          <p:nvPr/>
        </p:nvSpPr>
        <p:spPr>
          <a:xfrm>
            <a:off x="4201289" y="523778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KATO III</a:t>
            </a:r>
          </a:p>
          <a:p>
            <a:pPr algn="ctr"/>
            <a:r>
              <a:rPr lang="it-IT" sz="1000" dirty="0" err="1"/>
              <a:t>Vehicle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F2EFA6B2-1FBF-332E-157B-CEDA7A109071}"/>
              </a:ext>
            </a:extLst>
          </p:cNvPr>
          <p:cNvSpPr txBox="1"/>
          <p:nvPr/>
        </p:nvSpPr>
        <p:spPr>
          <a:xfrm>
            <a:off x="9617773" y="2947737"/>
            <a:ext cx="150551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SQSTM1/p62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CD9A5F6F-C94A-EF0E-5958-A645382D2E84}"/>
              </a:ext>
            </a:extLst>
          </p:cNvPr>
          <p:cNvSpPr txBox="1"/>
          <p:nvPr/>
        </p:nvSpPr>
        <p:spPr>
          <a:xfrm>
            <a:off x="9595184" y="3729789"/>
            <a:ext cx="7018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Actin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0E71A77C-6695-D237-9C04-5D1C30A78704}"/>
              </a:ext>
            </a:extLst>
          </p:cNvPr>
          <p:cNvSpPr txBox="1"/>
          <p:nvPr/>
        </p:nvSpPr>
        <p:spPr>
          <a:xfrm>
            <a:off x="9615237" y="5434263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LC3A/B</a:t>
            </a:r>
          </a:p>
        </p:txBody>
      </p:sp>
    </p:spTree>
    <p:extLst>
      <p:ext uri="{BB962C8B-B14F-4D97-AF65-F5344CB8AC3E}">
        <p14:creationId xmlns:p14="http://schemas.microsoft.com/office/powerpoint/2010/main" val="13920725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o 17">
            <a:extLst>
              <a:ext uri="{FF2B5EF4-FFF2-40B4-BE49-F238E27FC236}">
                <a16:creationId xmlns:a16="http://schemas.microsoft.com/office/drawing/2014/main" id="{B326D281-B1F0-60AB-0465-EAB75641DE28}"/>
              </a:ext>
            </a:extLst>
          </p:cNvPr>
          <p:cNvGrpSpPr/>
          <p:nvPr/>
        </p:nvGrpSpPr>
        <p:grpSpPr>
          <a:xfrm>
            <a:off x="3285900" y="1452620"/>
            <a:ext cx="6567734" cy="4442513"/>
            <a:chOff x="4108058" y="1758883"/>
            <a:chExt cx="6888576" cy="454277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55829C9-ABEA-D9A0-E0F0-A280567F80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1604" b="7143"/>
            <a:stretch>
              <a:fillRect/>
            </a:stretch>
          </p:blipFill>
          <p:spPr>
            <a:xfrm>
              <a:off x="4108058" y="1758883"/>
              <a:ext cx="6888567" cy="177777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A4F8650-A3FB-ACEC-4A28-981AD70D146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2609" r="1782" b="758"/>
            <a:stretch>
              <a:fillRect/>
            </a:stretch>
          </p:blipFill>
          <p:spPr>
            <a:xfrm>
              <a:off x="4120549" y="3531157"/>
              <a:ext cx="6876085" cy="2770502"/>
            </a:xfrm>
            <a:prstGeom prst="rect">
              <a:avLst/>
            </a:prstGeom>
          </p:spPr>
        </p:pic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58A7755B-6E37-FA4F-44DA-31598F6D1E6B}"/>
              </a:ext>
            </a:extLst>
          </p:cNvPr>
          <p:cNvSpPr txBox="1"/>
          <p:nvPr/>
        </p:nvSpPr>
        <p:spPr>
          <a:xfrm>
            <a:off x="9926052" y="4516394"/>
            <a:ext cx="87228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GPX4</a:t>
            </a:r>
          </a:p>
        </p:txBody>
      </p: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BD28ED32-38E8-9C7A-2296-3806A1EBF86A}"/>
              </a:ext>
            </a:extLst>
          </p:cNvPr>
          <p:cNvGrpSpPr/>
          <p:nvPr/>
        </p:nvGrpSpPr>
        <p:grpSpPr>
          <a:xfrm>
            <a:off x="3471076" y="880674"/>
            <a:ext cx="5880290" cy="434783"/>
            <a:chOff x="4441331" y="1284663"/>
            <a:chExt cx="4666894" cy="434783"/>
          </a:xfrm>
        </p:grpSpPr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EB37414F-4245-3416-D977-4A5DBB8ADBFE}"/>
                </a:ext>
              </a:extLst>
            </p:cNvPr>
            <p:cNvSpPr txBox="1"/>
            <p:nvPr/>
          </p:nvSpPr>
          <p:spPr>
            <a:xfrm>
              <a:off x="7981580" y="1308463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AC23D6E8-8C6E-8A10-7F45-699477E84A76}"/>
                </a:ext>
              </a:extLst>
            </p:cNvPr>
            <p:cNvSpPr txBox="1"/>
            <p:nvPr/>
          </p:nvSpPr>
          <p:spPr>
            <a:xfrm>
              <a:off x="8581403" y="1309309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AC5E7D0F-6E46-54B8-217D-D59198FCCC7E}"/>
                </a:ext>
              </a:extLst>
            </p:cNvPr>
            <p:cNvSpPr txBox="1"/>
            <p:nvPr/>
          </p:nvSpPr>
          <p:spPr>
            <a:xfrm>
              <a:off x="5678921" y="1284665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56A74A3E-11A9-4451-E8A8-2C8E218E278A}"/>
                </a:ext>
              </a:extLst>
            </p:cNvPr>
            <p:cNvSpPr txBox="1"/>
            <p:nvPr/>
          </p:nvSpPr>
          <p:spPr>
            <a:xfrm>
              <a:off x="6243851" y="131220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ADD04911-1C77-E6C3-7709-C784FFB39E3D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2F79687C-8219-AC3E-159B-5A1833F93FE0}"/>
                </a:ext>
              </a:extLst>
            </p:cNvPr>
            <p:cNvSpPr txBox="1"/>
            <p:nvPr/>
          </p:nvSpPr>
          <p:spPr>
            <a:xfrm>
              <a:off x="500994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2F11CC6B-1501-5F91-6819-65A0D77E6D69}"/>
                </a:ext>
              </a:extLst>
            </p:cNvPr>
            <p:cNvSpPr txBox="1"/>
            <p:nvPr/>
          </p:nvSpPr>
          <p:spPr>
            <a:xfrm>
              <a:off x="7257331" y="1309310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25AC58A5-2FC1-52DE-7739-7EAE39501396}"/>
                </a:ext>
              </a:extLst>
            </p:cNvPr>
            <p:cNvSpPr txBox="1"/>
            <p:nvPr/>
          </p:nvSpPr>
          <p:spPr>
            <a:xfrm>
              <a:off x="6648946" y="1319336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CA920FCE-93D5-CC44-51AF-085FC3566E7E}"/>
              </a:ext>
            </a:extLst>
          </p:cNvPr>
          <p:cNvSpPr txBox="1"/>
          <p:nvPr/>
        </p:nvSpPr>
        <p:spPr>
          <a:xfrm>
            <a:off x="9926053" y="1668921"/>
            <a:ext cx="102268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Vinculin</a:t>
            </a:r>
          </a:p>
        </p:txBody>
      </p: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BE3F36B8-302E-693E-9E80-7DED8EE1C041}"/>
              </a:ext>
            </a:extLst>
          </p:cNvPr>
          <p:cNvGrpSpPr/>
          <p:nvPr/>
        </p:nvGrpSpPr>
        <p:grpSpPr>
          <a:xfrm>
            <a:off x="877799" y="1275729"/>
            <a:ext cx="2407705" cy="4582701"/>
            <a:chOff x="562271" y="1725972"/>
            <a:chExt cx="2788704" cy="3433599"/>
          </a:xfrm>
        </p:grpSpPr>
        <p:pic>
          <p:nvPicPr>
            <p:cNvPr id="20" name="Immagine 19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61C300ED-F7A4-4C7A-2833-349EEC11F9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00FCBE2E-0259-9687-A4CF-1F9863A93275}"/>
                </a:ext>
              </a:extLst>
            </p:cNvPr>
            <p:cNvSpPr txBox="1"/>
            <p:nvPr/>
          </p:nvSpPr>
          <p:spPr>
            <a:xfrm>
              <a:off x="562271" y="4441541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/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>
                  <a:solidFill>
                    <a:srgbClr val="333333"/>
                  </a:solidFill>
                  <a:latin typeface="Aptos"/>
                </a:rPr>
                <a:t>, </a:t>
              </a:r>
              <a:endParaRPr lang="en-US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951434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>
            <a:extLst>
              <a:ext uri="{FF2B5EF4-FFF2-40B4-BE49-F238E27FC236}">
                <a16:creationId xmlns:a16="http://schemas.microsoft.com/office/drawing/2014/main" id="{E27A3388-5371-7E94-E363-2E8916B2B878}"/>
              </a:ext>
            </a:extLst>
          </p:cNvPr>
          <p:cNvGrpSpPr/>
          <p:nvPr/>
        </p:nvGrpSpPr>
        <p:grpSpPr>
          <a:xfrm>
            <a:off x="1744886" y="1443116"/>
            <a:ext cx="2598205" cy="5063963"/>
            <a:chOff x="562271" y="1725972"/>
            <a:chExt cx="2788704" cy="3433599"/>
          </a:xfrm>
        </p:grpSpPr>
        <p:pic>
          <p:nvPicPr>
            <p:cNvPr id="3" name="Immagine 2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C1B5D70D-CD33-CBD2-4F33-D6FA820EF1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A682419C-9085-23AD-6434-8C144A63873C}"/>
                </a:ext>
              </a:extLst>
            </p:cNvPr>
            <p:cNvSpPr txBox="1"/>
            <p:nvPr/>
          </p:nvSpPr>
          <p:spPr>
            <a:xfrm>
              <a:off x="562271" y="4441541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/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>
                  <a:solidFill>
                    <a:srgbClr val="333333"/>
                  </a:solidFill>
                  <a:latin typeface="Aptos"/>
                </a:rPr>
                <a:t>, </a:t>
              </a:r>
              <a:endParaRPr lang="en-US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/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09CF0ECA-2422-7498-30D6-0CEBB3248B97}"/>
              </a:ext>
            </a:extLst>
          </p:cNvPr>
          <p:cNvSpPr txBox="1"/>
          <p:nvPr/>
        </p:nvSpPr>
        <p:spPr>
          <a:xfrm>
            <a:off x="9292332" y="5276192"/>
            <a:ext cx="867095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GPX4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DC7FA9-83F3-5C74-1C29-840F665D2B19}"/>
              </a:ext>
            </a:extLst>
          </p:cNvPr>
          <p:cNvSpPr txBox="1"/>
          <p:nvPr/>
        </p:nvSpPr>
        <p:spPr>
          <a:xfrm>
            <a:off x="9292331" y="3788914"/>
            <a:ext cx="867095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Actin</a:t>
            </a:r>
          </a:p>
        </p:txBody>
      </p: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2B2EB357-B55B-790E-ACA1-7795391CAD44}"/>
              </a:ext>
            </a:extLst>
          </p:cNvPr>
          <p:cNvGrpSpPr/>
          <p:nvPr/>
        </p:nvGrpSpPr>
        <p:grpSpPr>
          <a:xfrm>
            <a:off x="4494581" y="1306899"/>
            <a:ext cx="4729605" cy="4945534"/>
            <a:chOff x="4680257" y="616599"/>
            <a:chExt cx="4729605" cy="494553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6D6CA5C-692E-6EB5-615A-86D6869440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80465" y="616599"/>
              <a:ext cx="4729397" cy="2002080"/>
            </a:xfrm>
            <a:prstGeom prst="rect">
              <a:avLst/>
            </a:prstGeom>
          </p:spPr>
        </p:pic>
        <p:pic>
          <p:nvPicPr>
            <p:cNvPr id="11" name="Immagine 10" descr="Immagine che contiene nero, monocromatico, bianco e nero, Fotografia monocromatic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FBB7E0DC-EC47-1B43-9644-DDBA7A0D88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47" t="30164" r="2044" b="262"/>
            <a:stretch>
              <a:fillRect/>
            </a:stretch>
          </p:blipFill>
          <p:spPr>
            <a:xfrm>
              <a:off x="4680257" y="3131053"/>
              <a:ext cx="4728331" cy="2431080"/>
            </a:xfrm>
            <a:prstGeom prst="rect">
              <a:avLst/>
            </a:prstGeom>
          </p:spPr>
        </p:pic>
        <p:pic>
          <p:nvPicPr>
            <p:cNvPr id="12" name="Immagine 11" descr="Immagine che contiene bianco, Fotografia monocromatica, bianco e nero,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145F1E01-579F-CB05-4F19-2394A265886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t="11175" r="-186" b="73011"/>
            <a:stretch>
              <a:fillRect/>
            </a:stretch>
          </p:blipFill>
          <p:spPr>
            <a:xfrm>
              <a:off x="4684463" y="2620749"/>
              <a:ext cx="4723494" cy="594744"/>
            </a:xfrm>
            <a:prstGeom prst="rect">
              <a:avLst/>
            </a:prstGeom>
          </p:spPr>
        </p:pic>
      </p:grpSp>
      <p:grpSp>
        <p:nvGrpSpPr>
          <p:cNvPr id="23" name="Gruppo 22">
            <a:extLst>
              <a:ext uri="{FF2B5EF4-FFF2-40B4-BE49-F238E27FC236}">
                <a16:creationId xmlns:a16="http://schemas.microsoft.com/office/drawing/2014/main" id="{16EEA64F-8F80-04E9-11A1-04C8B4681A3B}"/>
              </a:ext>
            </a:extLst>
          </p:cNvPr>
          <p:cNvGrpSpPr/>
          <p:nvPr/>
        </p:nvGrpSpPr>
        <p:grpSpPr>
          <a:xfrm>
            <a:off x="4458479" y="874605"/>
            <a:ext cx="4805038" cy="427654"/>
            <a:chOff x="4441331" y="1284663"/>
            <a:chExt cx="3813520" cy="427654"/>
          </a:xfrm>
        </p:grpSpPr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B1010B46-DC0E-0C1F-BDFF-5AE85DB4C856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/>
                <a:t>AGS</a:t>
              </a:r>
            </a:p>
            <a:p>
              <a:pPr algn="ctr"/>
              <a:r>
                <a:rPr lang="it-IT" sz="1000"/>
                <a:t>CTR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36D65F9D-3CC3-07E6-23AA-5E86C9C77B6B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/>
                <a:t>AGS</a:t>
              </a:r>
            </a:p>
            <a:p>
              <a:pPr algn="ctr"/>
              <a:r>
                <a:rPr lang="it-IT" sz="1000"/>
                <a:t>TRA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480C89CC-7E41-4AA8-6D47-DFA4FF6617F9}"/>
                </a:ext>
              </a:extLst>
            </p:cNvPr>
            <p:cNvSpPr txBox="1"/>
            <p:nvPr/>
          </p:nvSpPr>
          <p:spPr>
            <a:xfrm>
              <a:off x="5368583" y="1284665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0E61FFA6-6CA4-11AA-F4C0-4C15385C9EE1}"/>
                </a:ext>
              </a:extLst>
            </p:cNvPr>
            <p:cNvSpPr txBox="1"/>
            <p:nvPr/>
          </p:nvSpPr>
          <p:spPr>
            <a:xfrm>
              <a:off x="5845982" y="131220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/>
                <a:t>NCI</a:t>
              </a:r>
            </a:p>
            <a:p>
              <a:pPr algn="ctr"/>
              <a:r>
                <a:rPr lang="it-IT" sz="1000"/>
                <a:t>TRA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D65E3B50-CA5C-48DA-9DD4-7590EEC4178E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7B87021A-08C5-3A10-FF22-8427EA55779C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D4413652-8E5F-6EA5-7349-577094E68979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/>
                <a:t>KATO III</a:t>
              </a:r>
            </a:p>
            <a:p>
              <a:pPr algn="ctr"/>
              <a:r>
                <a:rPr lang="it-IT" sz="1000"/>
                <a:t>TRA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438BB1AF-36AF-1DDF-3A71-5DF18A7893BB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/>
                <a:t>KATO III</a:t>
              </a:r>
            </a:p>
            <a:p>
              <a:pPr algn="ctr"/>
              <a:r>
                <a:rPr lang="it-IT" sz="1000"/>
                <a:t>CTR</a:t>
              </a:r>
            </a:p>
          </p:txBody>
        </p:sp>
      </p:grp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5129185C-2DAE-A229-4389-F10C107661E6}"/>
              </a:ext>
            </a:extLst>
          </p:cNvPr>
          <p:cNvSpPr txBox="1"/>
          <p:nvPr/>
        </p:nvSpPr>
        <p:spPr>
          <a:xfrm>
            <a:off x="9262253" y="3417940"/>
            <a:ext cx="112777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SLC7A11</a:t>
            </a:r>
          </a:p>
        </p:txBody>
      </p:sp>
    </p:spTree>
    <p:extLst>
      <p:ext uri="{BB962C8B-B14F-4D97-AF65-F5344CB8AC3E}">
        <p14:creationId xmlns:p14="http://schemas.microsoft.com/office/powerpoint/2010/main" val="17254454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2E6EF831-2C01-7F8C-6DB9-C416CCEB859C}"/>
              </a:ext>
            </a:extLst>
          </p:cNvPr>
          <p:cNvGrpSpPr/>
          <p:nvPr/>
        </p:nvGrpSpPr>
        <p:grpSpPr>
          <a:xfrm>
            <a:off x="1597186" y="1636717"/>
            <a:ext cx="2317469" cy="4332042"/>
            <a:chOff x="562271" y="1725972"/>
            <a:chExt cx="2788704" cy="3433599"/>
          </a:xfrm>
        </p:grpSpPr>
        <p:pic>
          <p:nvPicPr>
            <p:cNvPr id="15" name="Immagine 14" descr="Immagine che contiene testo, schermata, software, Icona del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FF5C8EE3-206F-0ED5-AD06-0D57E6023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6506" t="34270" r="16717" b="25033"/>
            <a:stretch>
              <a:fillRect/>
            </a:stretch>
          </p:blipFill>
          <p:spPr>
            <a:xfrm>
              <a:off x="2386987" y="1725972"/>
              <a:ext cx="963988" cy="3433599"/>
            </a:xfrm>
            <a:prstGeom prst="rect">
              <a:avLst/>
            </a:prstGeom>
          </p:spPr>
        </p:pic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D44E02DD-5A29-1482-C055-407CB8B7377C}"/>
                </a:ext>
              </a:extLst>
            </p:cNvPr>
            <p:cNvSpPr txBox="1"/>
            <p:nvPr/>
          </p:nvSpPr>
          <p:spPr>
            <a:xfrm>
              <a:off x="562271" y="4441541"/>
              <a:ext cx="1457899" cy="6001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Protein MW Marker,</a:t>
              </a:r>
              <a:endParaRPr lang="it-IT" dirty="0"/>
            </a:p>
            <a:p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 Ladder, </a:t>
              </a:r>
              <a:r>
                <a:rPr lang="en-US" sz="1100" dirty="0" err="1">
                  <a:solidFill>
                    <a:srgbClr val="333333"/>
                  </a:solidFill>
                  <a:latin typeface="Aptos"/>
                </a:rPr>
                <a:t>Prestained</a:t>
              </a:r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, </a:t>
              </a:r>
              <a:endParaRPr lang="en-US" dirty="0">
                <a:solidFill>
                  <a:srgbClr val="000000"/>
                </a:solidFill>
                <a:latin typeface="Aptos"/>
              </a:endParaRPr>
            </a:p>
            <a:p>
              <a:r>
                <a:rPr lang="en-US" sz="1100" dirty="0">
                  <a:solidFill>
                    <a:srgbClr val="333333"/>
                  </a:solidFill>
                  <a:latin typeface="Aptos"/>
                </a:rPr>
                <a:t>10-170kD Marker</a:t>
              </a:r>
              <a:endParaRPr lang="en-US" dirty="0"/>
            </a:p>
          </p:txBody>
        </p:sp>
      </p:grp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730148FD-4780-99CA-6728-25A8CDA3D390}"/>
              </a:ext>
            </a:extLst>
          </p:cNvPr>
          <p:cNvSpPr txBox="1"/>
          <p:nvPr/>
        </p:nvSpPr>
        <p:spPr>
          <a:xfrm>
            <a:off x="8419597" y="2437980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PARP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3E20B298-4437-6207-1A6E-827BE7642982}"/>
              </a:ext>
            </a:extLst>
          </p:cNvPr>
          <p:cNvSpPr txBox="1"/>
          <p:nvPr/>
        </p:nvSpPr>
        <p:spPr>
          <a:xfrm>
            <a:off x="8419597" y="4613690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BAX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48D36F48-A2BA-14EF-FBA0-21E4554E84B3}"/>
              </a:ext>
            </a:extLst>
          </p:cNvPr>
          <p:cNvSpPr txBox="1"/>
          <p:nvPr/>
        </p:nvSpPr>
        <p:spPr>
          <a:xfrm>
            <a:off x="8419597" y="4252743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CASP3 </a:t>
            </a:r>
          </a:p>
        </p:txBody>
      </p:sp>
      <p:pic>
        <p:nvPicPr>
          <p:cNvPr id="2" name="Immagine 1" descr="Immagine che contiene monocromatico, nero, bianco e nero, Fotografia monocromatica&#10;&#10;Il contenuto generato dall&amp;#39;IA potrebbe non essere corretto.">
            <a:extLst>
              <a:ext uri="{FF2B5EF4-FFF2-40B4-BE49-F238E27FC236}">
                <a16:creationId xmlns:a16="http://schemas.microsoft.com/office/drawing/2014/main" id="{A1DA60E1-D1AC-D508-7C9E-DCBDFEBEF45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771" t="39628" r="4069" b="41552"/>
          <a:stretch>
            <a:fillRect/>
          </a:stretch>
        </p:blipFill>
        <p:spPr>
          <a:xfrm>
            <a:off x="3998128" y="4643125"/>
            <a:ext cx="4424287" cy="36704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A650778-145B-ABA1-7888-0AC513A946D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467" t="24902" r="413" b="-1018"/>
          <a:stretch>
            <a:fillRect/>
          </a:stretch>
        </p:blipFill>
        <p:spPr>
          <a:xfrm>
            <a:off x="3984417" y="3758887"/>
            <a:ext cx="4420633" cy="494022"/>
          </a:xfrm>
          <a:prstGeom prst="rect">
            <a:avLst/>
          </a:prstGeom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4B9A7082-9C35-D233-8A67-D16886894104}"/>
              </a:ext>
            </a:extLst>
          </p:cNvPr>
          <p:cNvSpPr txBox="1"/>
          <p:nvPr/>
        </p:nvSpPr>
        <p:spPr>
          <a:xfrm>
            <a:off x="8419597" y="3801558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Actin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5A6C1809-E3B4-387C-3E93-6CB34D96B588}"/>
              </a:ext>
            </a:extLst>
          </p:cNvPr>
          <p:cNvSpPr txBox="1"/>
          <p:nvPr/>
        </p:nvSpPr>
        <p:spPr>
          <a:xfrm>
            <a:off x="8419597" y="3320295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SLC7A11</a:t>
            </a:r>
          </a:p>
        </p:txBody>
      </p:sp>
      <p:grpSp>
        <p:nvGrpSpPr>
          <p:cNvPr id="34" name="Gruppo 33">
            <a:extLst>
              <a:ext uri="{FF2B5EF4-FFF2-40B4-BE49-F238E27FC236}">
                <a16:creationId xmlns:a16="http://schemas.microsoft.com/office/drawing/2014/main" id="{338CAC5C-BFBA-C087-3A86-E0E9E4559D2F}"/>
              </a:ext>
            </a:extLst>
          </p:cNvPr>
          <p:cNvGrpSpPr/>
          <p:nvPr/>
        </p:nvGrpSpPr>
        <p:grpSpPr>
          <a:xfrm>
            <a:off x="3909123" y="716681"/>
            <a:ext cx="4444090" cy="598101"/>
            <a:chOff x="4441331" y="1284663"/>
            <a:chExt cx="3813520" cy="427654"/>
          </a:xfrm>
        </p:grpSpPr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63FCDACC-49EB-FDB7-08BC-F99B2AB3442F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BFD22A3B-FEC9-5921-0F88-67BB307A4E91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FDD89B8C-B3DE-6338-1742-CEAB440032AF}"/>
                </a:ext>
              </a:extLst>
            </p:cNvPr>
            <p:cNvSpPr txBox="1"/>
            <p:nvPr/>
          </p:nvSpPr>
          <p:spPr>
            <a:xfrm>
              <a:off x="5368583" y="1284665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170A533C-D520-8075-217D-9C8A5DA60D71}"/>
                </a:ext>
              </a:extLst>
            </p:cNvPr>
            <p:cNvSpPr txBox="1"/>
            <p:nvPr/>
          </p:nvSpPr>
          <p:spPr>
            <a:xfrm>
              <a:off x="5845982" y="131220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2F286E71-F9A0-BB74-05F0-3371F4CF1C3F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5FB77165-E9DC-07C9-668F-7972B2541F48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2C9F7031-6445-3DE5-DA4D-04B17DB25451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41EE28E8-DF96-D9DE-1034-2389050F4809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351CED7D-2203-8572-1891-53F8DD06B6C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77" t="-264" r="3579"/>
          <a:stretch>
            <a:fillRect/>
          </a:stretch>
        </p:blipFill>
        <p:spPr>
          <a:xfrm>
            <a:off x="3998128" y="1477849"/>
            <a:ext cx="4423728" cy="160443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FC9D8CF-F217-309F-A30F-E440B115C71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785" t="472" r="432" b="3667"/>
          <a:stretch>
            <a:fillRect/>
          </a:stretch>
        </p:blipFill>
        <p:spPr>
          <a:xfrm>
            <a:off x="3984417" y="3081854"/>
            <a:ext cx="4439345" cy="68173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24D3F95-98DA-9E2E-78CD-D0647A382BC8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3648" t="985" r="214" b="63531"/>
          <a:stretch>
            <a:fillRect/>
          </a:stretch>
        </p:blipFill>
        <p:spPr>
          <a:xfrm>
            <a:off x="3998128" y="3836242"/>
            <a:ext cx="4415377" cy="780994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A98E6F4-385C-B178-A6AF-BD740330B399}"/>
              </a:ext>
            </a:extLst>
          </p:cNvPr>
          <p:cNvSpPr txBox="1"/>
          <p:nvPr/>
        </p:nvSpPr>
        <p:spPr>
          <a:xfrm>
            <a:off x="8419597" y="5088188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Survivin</a:t>
            </a:r>
          </a:p>
        </p:txBody>
      </p:sp>
      <p:pic>
        <p:nvPicPr>
          <p:cNvPr id="11" name="Immagine 10" descr="Immagine che contiene nero, Rettangolo, bianco, bianco e nero&#10;&#10;Il contenuto generato dall&amp;#39;IA potrebbe non essere corretto.">
            <a:extLst>
              <a:ext uri="{FF2B5EF4-FFF2-40B4-BE49-F238E27FC236}">
                <a16:creationId xmlns:a16="http://schemas.microsoft.com/office/drawing/2014/main" id="{66F3A3F8-92CF-9107-7DC2-6294B26930DC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2561" t="58113" r="3421" b="7170"/>
          <a:stretch>
            <a:fillRect/>
          </a:stretch>
        </p:blipFill>
        <p:spPr>
          <a:xfrm>
            <a:off x="3990520" y="5014002"/>
            <a:ext cx="4420323" cy="8638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583983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062B6D3-5028-D403-9920-E8DF10436BD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60" t="54545" r="-238" b="-350"/>
          <a:stretch>
            <a:fillRect/>
          </a:stretch>
        </p:blipFill>
        <p:spPr>
          <a:xfrm>
            <a:off x="4296918" y="3581676"/>
            <a:ext cx="3638009" cy="143742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3555127-DA42-5EF9-D67F-9B7B5C0A5F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16862" y="2146092"/>
            <a:ext cx="1438275" cy="60007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689AA46-D081-3F99-C219-D4523E663F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16862" y="4178092"/>
            <a:ext cx="1438275" cy="6000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C252C52-9483-CBB3-3802-AB856AAC1B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50347" y="1740314"/>
            <a:ext cx="1243221" cy="386328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800BCE7-B018-F6D9-E741-EC5E857B67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49074" y="2758177"/>
            <a:ext cx="3404290" cy="83364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7C6C417-5EDE-1209-7E82-B46FB953D9C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6934" t="40932" r="23432" b="37186"/>
          <a:stretch>
            <a:fillRect/>
          </a:stretch>
        </p:blipFill>
        <p:spPr>
          <a:xfrm>
            <a:off x="4440229" y="1888710"/>
            <a:ext cx="3418470" cy="862397"/>
          </a:xfrm>
          <a:prstGeom prst="rect">
            <a:avLst/>
          </a:prstGeom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E2EF47BA-9820-EB7E-DDA6-9505C90FEB3F}"/>
              </a:ext>
            </a:extLst>
          </p:cNvPr>
          <p:cNvGrpSpPr/>
          <p:nvPr/>
        </p:nvGrpSpPr>
        <p:grpSpPr>
          <a:xfrm>
            <a:off x="3429726" y="1064945"/>
            <a:ext cx="4698586" cy="839781"/>
            <a:chOff x="3429726" y="1064945"/>
            <a:chExt cx="4698586" cy="839781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33C7A6D-19CA-35B3-E1C1-A0428822559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33083" t="40135" r="34978" b="55157"/>
            <a:stretch>
              <a:fillRect/>
            </a:stretch>
          </p:blipFill>
          <p:spPr>
            <a:xfrm>
              <a:off x="3538492" y="1064945"/>
              <a:ext cx="4589820" cy="40919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46515AB-4BC9-7A5C-F840-4EF5F88B1190}"/>
                </a:ext>
              </a:extLst>
            </p:cNvPr>
            <p:cNvSpPr txBox="1"/>
            <p:nvPr/>
          </p:nvSpPr>
          <p:spPr>
            <a:xfrm>
              <a:off x="3429726" y="1488445"/>
              <a:ext cx="1734088" cy="2616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100" err="1">
                  <a:latin typeface="Arial"/>
                  <a:cs typeface="Arial"/>
                </a:rPr>
                <a:t>Salinomycin</a:t>
              </a:r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CD04C96-0A2B-82B8-2EFB-152336B09065}"/>
                </a:ext>
              </a:extLst>
            </p:cNvPr>
            <p:cNvSpPr txBox="1"/>
            <p:nvPr/>
          </p:nvSpPr>
          <p:spPr>
            <a:xfrm>
              <a:off x="4636519" y="1524350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30B4668-926B-6F4C-630E-CB771420CB84}"/>
                </a:ext>
              </a:extLst>
            </p:cNvPr>
            <p:cNvSpPr txBox="1"/>
            <p:nvPr/>
          </p:nvSpPr>
          <p:spPr>
            <a:xfrm>
              <a:off x="5310171" y="1535394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  -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E2EE397-064C-E668-361B-47DE642EA294}"/>
                </a:ext>
              </a:extLst>
            </p:cNvPr>
            <p:cNvSpPr txBox="1"/>
            <p:nvPr/>
          </p:nvSpPr>
          <p:spPr>
            <a:xfrm>
              <a:off x="6149475" y="1535393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7B6539A-F518-4662-34B6-7E2AE00CCDAC}"/>
                </a:ext>
              </a:extLst>
            </p:cNvPr>
            <p:cNvSpPr txBox="1"/>
            <p:nvPr/>
          </p:nvSpPr>
          <p:spPr>
            <a:xfrm>
              <a:off x="6878344" y="1524349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4638983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AA73B79-9E2C-E7D2-06E7-5FFD61ABD42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5787" t="33521" r="20905" b="43570"/>
          <a:stretch>
            <a:fillRect/>
          </a:stretch>
        </p:blipFill>
        <p:spPr>
          <a:xfrm>
            <a:off x="3776633" y="2151068"/>
            <a:ext cx="4668999" cy="897687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8798B8D-2484-C489-6DB6-CE5F5F2F24C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8" t="32273" r="152" b="-455"/>
          <a:stretch>
            <a:fillRect/>
          </a:stretch>
        </p:blipFill>
        <p:spPr>
          <a:xfrm>
            <a:off x="3762169" y="3047581"/>
            <a:ext cx="4665096" cy="167162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FC85465-156F-C406-A056-6C076072EF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5905" y="2554701"/>
            <a:ext cx="1438275" cy="60007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395330F-F427-A85A-B954-0657B2E23B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42670" y="3162092"/>
            <a:ext cx="1800225" cy="6000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84B1AB4-6C57-DFBD-F3EE-731D9790DC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19651" y="2152513"/>
            <a:ext cx="1276350" cy="3171410"/>
          </a:xfrm>
          <a:prstGeom prst="rect">
            <a:avLst/>
          </a:prstGeom>
        </p:spPr>
      </p:pic>
      <p:grpSp>
        <p:nvGrpSpPr>
          <p:cNvPr id="18" name="Group 17">
            <a:extLst>
              <a:ext uri="{FF2B5EF4-FFF2-40B4-BE49-F238E27FC236}">
                <a16:creationId xmlns:a16="http://schemas.microsoft.com/office/drawing/2014/main" id="{BBA2CAC8-8C9C-091D-E97A-059F22A3A6EC}"/>
              </a:ext>
            </a:extLst>
          </p:cNvPr>
          <p:cNvGrpSpPr/>
          <p:nvPr/>
        </p:nvGrpSpPr>
        <p:grpSpPr>
          <a:xfrm>
            <a:off x="3264074" y="1230598"/>
            <a:ext cx="5151368" cy="917085"/>
            <a:chOff x="3429726" y="1064945"/>
            <a:chExt cx="4698586" cy="839781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F3026D77-404B-0006-30FA-F5CC7F02BBC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33083" t="40135" r="34978" b="55157"/>
            <a:stretch>
              <a:fillRect/>
            </a:stretch>
          </p:blipFill>
          <p:spPr>
            <a:xfrm>
              <a:off x="3538492" y="1064945"/>
              <a:ext cx="4589820" cy="409195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41B626C-E182-1DA7-D274-4CE3FCB8F5DF}"/>
                </a:ext>
              </a:extLst>
            </p:cNvPr>
            <p:cNvSpPr txBox="1"/>
            <p:nvPr/>
          </p:nvSpPr>
          <p:spPr>
            <a:xfrm>
              <a:off x="3429726" y="1488445"/>
              <a:ext cx="1734088" cy="2616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100" err="1">
                  <a:latin typeface="Arial"/>
                  <a:cs typeface="Arial"/>
                </a:rPr>
                <a:t>Salinomycin</a:t>
              </a:r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64789EC-F939-550A-F12C-2D8E9B085CD5}"/>
                </a:ext>
              </a:extLst>
            </p:cNvPr>
            <p:cNvSpPr txBox="1"/>
            <p:nvPr/>
          </p:nvSpPr>
          <p:spPr>
            <a:xfrm>
              <a:off x="4636519" y="1524350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1A89729-2A17-6699-BB32-6619568B750B}"/>
                </a:ext>
              </a:extLst>
            </p:cNvPr>
            <p:cNvSpPr txBox="1"/>
            <p:nvPr/>
          </p:nvSpPr>
          <p:spPr>
            <a:xfrm>
              <a:off x="5310171" y="1535394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  -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1D865A1-6A0E-D617-1E4B-A58801C9D96A}"/>
                </a:ext>
              </a:extLst>
            </p:cNvPr>
            <p:cNvSpPr txBox="1"/>
            <p:nvPr/>
          </p:nvSpPr>
          <p:spPr>
            <a:xfrm>
              <a:off x="6149475" y="1535393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2CB9474-5099-0E1C-97E5-8BBF5FAEC4D7}"/>
                </a:ext>
              </a:extLst>
            </p:cNvPr>
            <p:cNvSpPr txBox="1"/>
            <p:nvPr/>
          </p:nvSpPr>
          <p:spPr>
            <a:xfrm>
              <a:off x="6878344" y="1524349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41600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F943FD-311B-9174-B0AC-6E7C46643DC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asellaDiTesto 9">
            <a:extLst>
              <a:ext uri="{FF2B5EF4-FFF2-40B4-BE49-F238E27FC236}">
                <a16:creationId xmlns:a16="http://schemas.microsoft.com/office/drawing/2014/main" id="{1F842F96-965F-3550-8787-16A5CEF2F42D}"/>
              </a:ext>
            </a:extLst>
          </p:cNvPr>
          <p:cNvSpPr txBox="1"/>
          <p:nvPr/>
        </p:nvSpPr>
        <p:spPr>
          <a:xfrm>
            <a:off x="1980668" y="1832616"/>
            <a:ext cx="175628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err="1"/>
              <a:t>mTOR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38C32BE9-5973-CD13-2316-C84ADCC01E69}"/>
              </a:ext>
            </a:extLst>
          </p:cNvPr>
          <p:cNvSpPr txBox="1"/>
          <p:nvPr/>
        </p:nvSpPr>
        <p:spPr>
          <a:xfrm>
            <a:off x="1803578" y="3989241"/>
            <a:ext cx="98425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GAPDH</a:t>
            </a:r>
          </a:p>
        </p:txBody>
      </p:sp>
      <p:pic>
        <p:nvPicPr>
          <p:cNvPr id="4" name="Immagine 3" descr="Immagine che contiene testo, elettronica, schermata, software&#10;&#10;Il contenuto generato dall&amp;#39;IA potrebbe non essere corretto.">
            <a:extLst>
              <a:ext uri="{FF2B5EF4-FFF2-40B4-BE49-F238E27FC236}">
                <a16:creationId xmlns:a16="http://schemas.microsoft.com/office/drawing/2014/main" id="{002DA1C0-35A3-95D5-1882-CA185FE759B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0346" t="36011" r="60316" b="27673"/>
          <a:stretch>
            <a:fillRect/>
          </a:stretch>
        </p:blipFill>
        <p:spPr>
          <a:xfrm>
            <a:off x="8377041" y="1362194"/>
            <a:ext cx="1736114" cy="5176728"/>
          </a:xfrm>
          <a:prstGeom prst="rect">
            <a:avLst/>
          </a:prstGeom>
          <a:ln>
            <a:noFill/>
          </a:ln>
        </p:spPr>
      </p:pic>
      <p:pic>
        <p:nvPicPr>
          <p:cNvPr id="3" name="Immagine 2" descr="Immagine che contiene testo, schermata, software, Software multimediale&#10;&#10;Il contenuto generato dall&amp;#39;IA potrebbe non essere corretto.">
            <a:extLst>
              <a:ext uri="{FF2B5EF4-FFF2-40B4-BE49-F238E27FC236}">
                <a16:creationId xmlns:a16="http://schemas.microsoft.com/office/drawing/2014/main" id="{8E66CB04-752B-AB51-22F1-104E4AADDFB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6265" t="33735" r="55271" b="59400"/>
          <a:stretch>
            <a:fillRect/>
          </a:stretch>
        </p:blipFill>
        <p:spPr>
          <a:xfrm>
            <a:off x="2855320" y="3649405"/>
            <a:ext cx="5462548" cy="516711"/>
          </a:xfrm>
          <a:prstGeom prst="rect">
            <a:avLst/>
          </a:prstGeom>
        </p:spPr>
      </p:pic>
      <p:grpSp>
        <p:nvGrpSpPr>
          <p:cNvPr id="8" name="Gruppo 7">
            <a:extLst>
              <a:ext uri="{FF2B5EF4-FFF2-40B4-BE49-F238E27FC236}">
                <a16:creationId xmlns:a16="http://schemas.microsoft.com/office/drawing/2014/main" id="{53CEB244-F87D-3A35-E836-9EE126909905}"/>
              </a:ext>
            </a:extLst>
          </p:cNvPr>
          <p:cNvGrpSpPr/>
          <p:nvPr/>
        </p:nvGrpSpPr>
        <p:grpSpPr>
          <a:xfrm>
            <a:off x="2855299" y="1075560"/>
            <a:ext cx="5477805" cy="4972519"/>
            <a:chOff x="3360124" y="1327963"/>
            <a:chExt cx="5477805" cy="4972519"/>
          </a:xfrm>
        </p:grpSpPr>
        <p:pic>
          <p:nvPicPr>
            <p:cNvPr id="6" name="Immagine 5" descr="Immagine che contiene bianco, nero, bianco e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61AF94CF-E054-91CF-919B-60002B0AC19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15224" r="-169" b="-606"/>
            <a:stretch>
              <a:fillRect/>
            </a:stretch>
          </p:blipFill>
          <p:spPr>
            <a:xfrm>
              <a:off x="3360124" y="1327963"/>
              <a:ext cx="5477805" cy="1297297"/>
            </a:xfrm>
            <a:prstGeom prst="rect">
              <a:avLst/>
            </a:prstGeom>
          </p:spPr>
        </p:pic>
        <p:pic>
          <p:nvPicPr>
            <p:cNvPr id="14" name="Immagine 13" descr="Immagine che contiene bianco e nero, Rettangolo, Proprietà materiale, bian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F140132A-1DD7-F511-A21D-F407D4AAEB6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565" t="11789" r="1187" b="7317"/>
            <a:stretch>
              <a:fillRect/>
            </a:stretch>
          </p:blipFill>
          <p:spPr>
            <a:xfrm>
              <a:off x="3363542" y="4426540"/>
              <a:ext cx="5462187" cy="1873942"/>
            </a:xfrm>
            <a:prstGeom prst="rect">
              <a:avLst/>
            </a:prstGeom>
          </p:spPr>
        </p:pic>
        <p:pic>
          <p:nvPicPr>
            <p:cNvPr id="2" name="Immagine 1" descr="Immagine che contiene nero, bianco e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7E0F0FD5-19EF-7A5D-0A53-8754B1018CB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44000" r="-196" b="-1333"/>
            <a:stretch>
              <a:fillRect/>
            </a:stretch>
          </p:blipFill>
          <p:spPr>
            <a:xfrm>
              <a:off x="3363328" y="4416342"/>
              <a:ext cx="5455319" cy="501603"/>
            </a:xfrm>
            <a:prstGeom prst="rect">
              <a:avLst/>
            </a:prstGeom>
          </p:spPr>
        </p:pic>
        <p:pic>
          <p:nvPicPr>
            <p:cNvPr id="11" name="Immagine 10" descr="Immagine che contiene schermata, nero, bianco e nero, bian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BDD2B044-D85A-770D-31B5-722D5BA8383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t="-163" r="-168" b="4154"/>
            <a:stretch>
              <a:fillRect/>
            </a:stretch>
          </p:blipFill>
          <p:spPr>
            <a:xfrm>
              <a:off x="3364433" y="2559725"/>
              <a:ext cx="5463764" cy="1380876"/>
            </a:xfrm>
            <a:prstGeom prst="rect">
              <a:avLst/>
            </a:prstGeom>
          </p:spPr>
        </p:pic>
      </p:grp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F36F00D4-EAD1-B2A0-09A2-00FA05427404}"/>
              </a:ext>
            </a:extLst>
          </p:cNvPr>
          <p:cNvGrpSpPr/>
          <p:nvPr/>
        </p:nvGrpSpPr>
        <p:grpSpPr>
          <a:xfrm>
            <a:off x="3386510" y="672044"/>
            <a:ext cx="4557159" cy="581540"/>
            <a:chOff x="4441331" y="1207721"/>
            <a:chExt cx="3813520" cy="581540"/>
          </a:xfrm>
        </p:grpSpPr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85290F5C-1E74-DF0C-9832-3D9D2B5DCB51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E72AC4CB-E725-98F7-72E1-FB1183345205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B01A8D62-58AB-59A5-8372-9DC7752641AB}"/>
                </a:ext>
              </a:extLst>
            </p:cNvPr>
            <p:cNvSpPr txBox="1"/>
            <p:nvPr/>
          </p:nvSpPr>
          <p:spPr>
            <a:xfrm>
              <a:off x="5368583" y="1207721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79F6DFB2-AAEF-B960-BDE1-358B0D17B0A6}"/>
                </a:ext>
              </a:extLst>
            </p:cNvPr>
            <p:cNvSpPr txBox="1"/>
            <p:nvPr/>
          </p:nvSpPr>
          <p:spPr>
            <a:xfrm>
              <a:off x="5845982" y="1235263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9444D6E6-F2B4-A0EF-466D-FD8A47988B3B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5CE134D5-4D9F-EF21-27BA-15F6CFD749DF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37A91BC4-8A80-FCBF-7A11-C8D772129AE7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A37E3D86-2A59-3AAC-DEFE-CD4C538E9E2B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56181DC-75F0-A9D5-AC63-49637D2303D2}"/>
              </a:ext>
            </a:extLst>
          </p:cNvPr>
          <p:cNvSpPr txBox="1"/>
          <p:nvPr/>
        </p:nvSpPr>
        <p:spPr>
          <a:xfrm>
            <a:off x="1352580" y="3377124"/>
            <a:ext cx="150551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SQSTM1/p62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8FDB3BDA-3999-824C-B50A-37414431AE37}"/>
              </a:ext>
            </a:extLst>
          </p:cNvPr>
          <p:cNvSpPr txBox="1"/>
          <p:nvPr/>
        </p:nvSpPr>
        <p:spPr>
          <a:xfrm>
            <a:off x="9144393" y="6308089"/>
            <a:ext cx="2743200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solidFill>
                  <a:srgbClr val="1C2721"/>
                </a:solidFill>
                <a:latin typeface="Aptos"/>
              </a:rPr>
              <a:t>Precision Plus Protein™ Kaleidoscope™ </a:t>
            </a:r>
            <a:r>
              <a:rPr lang="en-US" sz="1200" dirty="0" err="1">
                <a:solidFill>
                  <a:srgbClr val="1C2721"/>
                </a:solidFill>
                <a:latin typeface="Aptos"/>
              </a:rPr>
              <a:t>Prestained</a:t>
            </a:r>
            <a:r>
              <a:rPr lang="en-US" sz="1200" dirty="0">
                <a:solidFill>
                  <a:srgbClr val="1C2721"/>
                </a:solidFill>
                <a:latin typeface="Aptos"/>
              </a:rPr>
              <a:t> Protein Standards</a:t>
            </a:r>
          </a:p>
        </p:txBody>
      </p:sp>
    </p:spTree>
    <p:extLst>
      <p:ext uri="{BB962C8B-B14F-4D97-AF65-F5344CB8AC3E}">
        <p14:creationId xmlns:p14="http://schemas.microsoft.com/office/powerpoint/2010/main" val="226428046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97222D3-325C-83B2-4717-2D3981EA79A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22917" r="-51" b="43269"/>
          <a:stretch>
            <a:fillRect/>
          </a:stretch>
        </p:blipFill>
        <p:spPr>
          <a:xfrm>
            <a:off x="3757613" y="2583720"/>
            <a:ext cx="4679136" cy="107575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40C8D85-58D0-1F77-EF6A-2243B4B8EA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35905" y="1836875"/>
            <a:ext cx="1438275" cy="6000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00028E3-242D-641F-C264-CBF2E2896D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5905" y="2830788"/>
            <a:ext cx="1438275" cy="6000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07828F0-4BB5-E155-9852-0BC7118084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35905" y="4156006"/>
            <a:ext cx="1438275" cy="6000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E8AAA38-9532-626D-1384-D1BEE13488E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76086" y="1842950"/>
            <a:ext cx="1276350" cy="372427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716606E-F88A-D8A3-5AE2-82A352571E73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0290" t="43366" r="27264" b="28525"/>
          <a:stretch>
            <a:fillRect/>
          </a:stretch>
        </p:blipFill>
        <p:spPr>
          <a:xfrm>
            <a:off x="3754783" y="3599055"/>
            <a:ext cx="4726628" cy="145213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467DA64-131B-4507-BD74-D128D2AB356B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25456" t="30528" r="24876" b="56842"/>
          <a:stretch>
            <a:fillRect/>
          </a:stretch>
        </p:blipFill>
        <p:spPr>
          <a:xfrm>
            <a:off x="3744155" y="1938832"/>
            <a:ext cx="4719167" cy="639974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3E8C31AA-2208-E536-3F19-3075D3BE1369}"/>
              </a:ext>
            </a:extLst>
          </p:cNvPr>
          <p:cNvGrpSpPr/>
          <p:nvPr/>
        </p:nvGrpSpPr>
        <p:grpSpPr>
          <a:xfrm>
            <a:off x="2767118" y="910337"/>
            <a:ext cx="5902324" cy="972301"/>
            <a:chOff x="3429726" y="1064945"/>
            <a:chExt cx="4698586" cy="839781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21D5BAF-7034-D01C-990B-67F1BD45FE9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l="33083" t="40135" r="34978" b="55157"/>
            <a:stretch>
              <a:fillRect/>
            </a:stretch>
          </p:blipFill>
          <p:spPr>
            <a:xfrm>
              <a:off x="3538492" y="1064945"/>
              <a:ext cx="4589820" cy="40919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BE7CD1F-0ECE-5906-D4B7-0B12CCA6C5CA}"/>
                </a:ext>
              </a:extLst>
            </p:cNvPr>
            <p:cNvSpPr txBox="1"/>
            <p:nvPr/>
          </p:nvSpPr>
          <p:spPr>
            <a:xfrm>
              <a:off x="3429726" y="1488445"/>
              <a:ext cx="1734088" cy="2616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100" err="1">
                  <a:latin typeface="Arial"/>
                  <a:cs typeface="Arial"/>
                </a:rPr>
                <a:t>Salinomycin</a:t>
              </a:r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224DF02-1832-D215-2036-A713593573A7}"/>
                </a:ext>
              </a:extLst>
            </p:cNvPr>
            <p:cNvSpPr txBox="1"/>
            <p:nvPr/>
          </p:nvSpPr>
          <p:spPr>
            <a:xfrm>
              <a:off x="4636519" y="1524350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01DAF14-5C0F-B788-243E-F4918C60A70D}"/>
                </a:ext>
              </a:extLst>
            </p:cNvPr>
            <p:cNvSpPr txBox="1"/>
            <p:nvPr/>
          </p:nvSpPr>
          <p:spPr>
            <a:xfrm>
              <a:off x="5310171" y="1535394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  -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10E62F1-C12B-ADFA-5029-69F1A53A65C5}"/>
                </a:ext>
              </a:extLst>
            </p:cNvPr>
            <p:cNvSpPr txBox="1"/>
            <p:nvPr/>
          </p:nvSpPr>
          <p:spPr>
            <a:xfrm>
              <a:off x="6149475" y="1535393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43D6BCB-6679-26E6-46AF-400B03C5DA11}"/>
                </a:ext>
              </a:extLst>
            </p:cNvPr>
            <p:cNvSpPr txBox="1"/>
            <p:nvPr/>
          </p:nvSpPr>
          <p:spPr>
            <a:xfrm>
              <a:off x="6878344" y="1524349"/>
              <a:ext cx="1063069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dirty="0"/>
                <a:t>+     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652256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9CD13AC-8D05-9496-3706-79B3532751F6}"/>
              </a:ext>
            </a:extLst>
          </p:cNvPr>
          <p:cNvSpPr txBox="1"/>
          <p:nvPr/>
        </p:nvSpPr>
        <p:spPr>
          <a:xfrm>
            <a:off x="1951970" y="4496797"/>
            <a:ext cx="1014335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err="1"/>
              <a:t>Survivin</a:t>
            </a:r>
            <a:r>
              <a:rPr lang="it-IT"/>
              <a:t> </a:t>
            </a:r>
          </a:p>
          <a:p>
            <a:endParaRPr lang="it-IT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6189ED77-7E6E-B98B-D72A-EC204A34646D}"/>
              </a:ext>
            </a:extLst>
          </p:cNvPr>
          <p:cNvSpPr txBox="1"/>
          <p:nvPr/>
        </p:nvSpPr>
        <p:spPr>
          <a:xfrm>
            <a:off x="2252758" y="4055155"/>
            <a:ext cx="59323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BAX 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3BD5726-B7C3-FA5D-8DEF-B4A6AD432BF3}"/>
              </a:ext>
            </a:extLst>
          </p:cNvPr>
          <p:cNvSpPr txBox="1"/>
          <p:nvPr/>
        </p:nvSpPr>
        <p:spPr>
          <a:xfrm>
            <a:off x="2050660" y="2150999"/>
            <a:ext cx="79375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err="1"/>
              <a:t>mTOR</a:t>
            </a:r>
            <a:r>
              <a:rPr lang="it-IT"/>
              <a:t> </a:t>
            </a:r>
          </a:p>
        </p:txBody>
      </p:sp>
      <p:pic>
        <p:nvPicPr>
          <p:cNvPr id="2" name="Immagine 1" descr="Immagine che contiene testo, elettronica, schermata, software&#10;&#10;Il contenuto generato dall&amp;#39;IA potrebbe non essere corretto.">
            <a:extLst>
              <a:ext uri="{FF2B5EF4-FFF2-40B4-BE49-F238E27FC236}">
                <a16:creationId xmlns:a16="http://schemas.microsoft.com/office/drawing/2014/main" id="{F30D6F63-88EF-98BD-6F3A-6D562DB3C48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0346" t="36011" r="60316" b="27673"/>
          <a:stretch>
            <a:fillRect/>
          </a:stretch>
        </p:blipFill>
        <p:spPr>
          <a:xfrm>
            <a:off x="7800274" y="1270586"/>
            <a:ext cx="1634188" cy="4299195"/>
          </a:xfrm>
          <a:prstGeom prst="rect">
            <a:avLst/>
          </a:prstGeom>
          <a:ln>
            <a:noFill/>
          </a:ln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9CF9D94A-B63A-5DDD-7F16-421B1D4A1B1E}"/>
              </a:ext>
            </a:extLst>
          </p:cNvPr>
          <p:cNvSpPr txBox="1"/>
          <p:nvPr/>
        </p:nvSpPr>
        <p:spPr>
          <a:xfrm>
            <a:off x="8020443" y="5573521"/>
            <a:ext cx="2743200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solidFill>
                  <a:srgbClr val="1C2721"/>
                </a:solidFill>
                <a:latin typeface="Aptos"/>
              </a:rPr>
              <a:t>Precision Plus Protein™ Kaleidoscope™ </a:t>
            </a:r>
            <a:r>
              <a:rPr lang="en-US" sz="1200" dirty="0" err="1">
                <a:solidFill>
                  <a:srgbClr val="1C2721"/>
                </a:solidFill>
                <a:latin typeface="Aptos"/>
              </a:rPr>
              <a:t>Prestained</a:t>
            </a:r>
            <a:r>
              <a:rPr lang="en-US" sz="1200" dirty="0">
                <a:solidFill>
                  <a:srgbClr val="1C2721"/>
                </a:solidFill>
                <a:latin typeface="Aptos"/>
              </a:rPr>
              <a:t> Protein Standards</a:t>
            </a:r>
          </a:p>
        </p:txBody>
      </p: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0C042735-A53C-39F4-38B0-D6526CC9EE8A}"/>
              </a:ext>
            </a:extLst>
          </p:cNvPr>
          <p:cNvGrpSpPr/>
          <p:nvPr/>
        </p:nvGrpSpPr>
        <p:grpSpPr>
          <a:xfrm>
            <a:off x="2942972" y="1151392"/>
            <a:ext cx="4855688" cy="4335592"/>
            <a:chOff x="3790697" y="1799092"/>
            <a:chExt cx="4855688" cy="4335592"/>
          </a:xfrm>
        </p:grpSpPr>
        <p:pic>
          <p:nvPicPr>
            <p:cNvPr id="10" name="Immagine 9" descr="Immagine che contiene nero, bianco, bianco e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E6FEE50D-2202-31F5-1342-AE071CCFCA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4585" t="47931" r="790" b="-6719"/>
            <a:stretch>
              <a:fillRect/>
            </a:stretch>
          </p:blipFill>
          <p:spPr>
            <a:xfrm>
              <a:off x="3810779" y="5161573"/>
              <a:ext cx="4815782" cy="973111"/>
            </a:xfrm>
            <a:prstGeom prst="rect">
              <a:avLst/>
            </a:prstGeom>
          </p:spPr>
        </p:pic>
        <p:pic>
          <p:nvPicPr>
            <p:cNvPr id="9" name="Immagine 8" descr="Immagine che contiene bianco, nero, bianco e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4DDFC737-38EB-F171-E4A4-29C2B9F7A1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387" r="1946" b="-914"/>
            <a:stretch>
              <a:fillRect/>
            </a:stretch>
          </p:blipFill>
          <p:spPr>
            <a:xfrm>
              <a:off x="3790697" y="1799092"/>
              <a:ext cx="4819066" cy="147065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Immagine 5" descr="Immagine che contiene nero, schermata, bianco e ner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662736AE-5FFB-775B-F76E-8D04A7D77D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398" t="42553" r="1193" b="26383"/>
            <a:stretch>
              <a:fillRect/>
            </a:stretch>
          </p:blipFill>
          <p:spPr>
            <a:xfrm>
              <a:off x="3810779" y="4415114"/>
              <a:ext cx="4835606" cy="733802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19166DB0-17F3-5C3C-D7D7-3C221BDCD15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6522" t="52113" r="4590" b="20123"/>
            <a:stretch>
              <a:fillRect/>
            </a:stretch>
          </p:blipFill>
          <p:spPr>
            <a:xfrm>
              <a:off x="3802981" y="4192908"/>
              <a:ext cx="4827236" cy="209105"/>
            </a:xfrm>
            <a:prstGeom prst="rect">
              <a:avLst/>
            </a:prstGeom>
          </p:spPr>
        </p:pic>
        <p:pic>
          <p:nvPicPr>
            <p:cNvPr id="17" name="Immagine 16" descr="Immagine che contiene bianco e nero, bianco, nero, Fotografia monocromatic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4D2F0890-01D8-4480-532C-CD0A71FDF03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1159" t="18605" r="3578" b="6667"/>
            <a:stretch>
              <a:fillRect/>
            </a:stretch>
          </p:blipFill>
          <p:spPr>
            <a:xfrm>
              <a:off x="3803208" y="3174136"/>
              <a:ext cx="4811015" cy="972475"/>
            </a:xfrm>
            <a:prstGeom prst="rect">
              <a:avLst/>
            </a:prstGeom>
          </p:spPr>
        </p:pic>
      </p:grp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81F34F12-6D6D-CFF8-CE40-E91DE505B77F}"/>
              </a:ext>
            </a:extLst>
          </p:cNvPr>
          <p:cNvSpPr txBox="1"/>
          <p:nvPr/>
        </p:nvSpPr>
        <p:spPr>
          <a:xfrm>
            <a:off x="1982047" y="3503707"/>
            <a:ext cx="98425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GAPDH</a:t>
            </a:r>
          </a:p>
        </p:txBody>
      </p:sp>
      <p:grpSp>
        <p:nvGrpSpPr>
          <p:cNvPr id="33" name="Gruppo 32">
            <a:extLst>
              <a:ext uri="{FF2B5EF4-FFF2-40B4-BE49-F238E27FC236}">
                <a16:creationId xmlns:a16="http://schemas.microsoft.com/office/drawing/2014/main" id="{9B63856E-82C5-F1C0-625E-864AC47390EF}"/>
              </a:ext>
            </a:extLst>
          </p:cNvPr>
          <p:cNvGrpSpPr/>
          <p:nvPr/>
        </p:nvGrpSpPr>
        <p:grpSpPr>
          <a:xfrm>
            <a:off x="3098694" y="1075470"/>
            <a:ext cx="4557160" cy="581540"/>
            <a:chOff x="4441331" y="1207721"/>
            <a:chExt cx="3813520" cy="581540"/>
          </a:xfrm>
        </p:grpSpPr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17D3352B-D4FB-67EF-DDD1-AB4689508F38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E7E92076-BA9B-BE94-0117-AF64097C6613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95DB9DAF-4786-9E26-E9FF-494AF9DBE046}"/>
                </a:ext>
              </a:extLst>
            </p:cNvPr>
            <p:cNvSpPr txBox="1"/>
            <p:nvPr/>
          </p:nvSpPr>
          <p:spPr>
            <a:xfrm>
              <a:off x="5368583" y="1207721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5BC8B056-AC89-4180-6375-9E0112BFC65B}"/>
                </a:ext>
              </a:extLst>
            </p:cNvPr>
            <p:cNvSpPr txBox="1"/>
            <p:nvPr/>
          </p:nvSpPr>
          <p:spPr>
            <a:xfrm>
              <a:off x="5845982" y="1235263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E21BB15F-8515-853A-867C-4B7014055707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CB9F5B61-44EF-0D4E-514C-1731A83A4AC5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7D75502F-5534-8964-9D6A-30BAB4DDB311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4DEB78AD-4AA6-5530-7A45-E86018BEFD52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727126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Immagine che contiene bianco e nero, nero, bianco, monocromatico&#10;&#10;Il contenuto generato dall&amp;#39;IA potrebbe non essere corretto.">
            <a:extLst>
              <a:ext uri="{FF2B5EF4-FFF2-40B4-BE49-F238E27FC236}">
                <a16:creationId xmlns:a16="http://schemas.microsoft.com/office/drawing/2014/main" id="{CA4319EC-A3E0-FC07-EC67-0D1AB378305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336" t="39726" r="2827" b="3425"/>
          <a:stretch>
            <a:fillRect/>
          </a:stretch>
        </p:blipFill>
        <p:spPr>
          <a:xfrm>
            <a:off x="2976523" y="1591758"/>
            <a:ext cx="4959834" cy="763500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AC4D7E2F-8CA4-A279-42E4-7B9F85E78723}"/>
              </a:ext>
            </a:extLst>
          </p:cNvPr>
          <p:cNvSpPr txBox="1"/>
          <p:nvPr/>
        </p:nvSpPr>
        <p:spPr>
          <a:xfrm>
            <a:off x="2128565" y="4853956"/>
            <a:ext cx="59323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BAX </a:t>
            </a:r>
          </a:p>
        </p:txBody>
      </p:sp>
      <p:pic>
        <p:nvPicPr>
          <p:cNvPr id="7" name="Immagine 6" descr="Immagine che contiene testo, schermata, Software multimediale, software&#10;&#10;Il contenuto generato dall&amp;#39;IA potrebbe non essere corretto.">
            <a:extLst>
              <a:ext uri="{FF2B5EF4-FFF2-40B4-BE49-F238E27FC236}">
                <a16:creationId xmlns:a16="http://schemas.microsoft.com/office/drawing/2014/main" id="{AB6C03D5-1734-737D-54C4-3D0C8CAF27C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4651" t="56981" r="6722" b="27839"/>
          <a:stretch>
            <a:fillRect/>
          </a:stretch>
        </p:blipFill>
        <p:spPr>
          <a:xfrm>
            <a:off x="2846521" y="4540448"/>
            <a:ext cx="5089836" cy="127226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DB39B909-F999-E891-C9F1-E4C44FE9C5E7}"/>
              </a:ext>
            </a:extLst>
          </p:cNvPr>
          <p:cNvSpPr txBox="1"/>
          <p:nvPr/>
        </p:nvSpPr>
        <p:spPr>
          <a:xfrm>
            <a:off x="1889760" y="5223288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Survivin ​</a:t>
            </a:r>
          </a:p>
        </p:txBody>
      </p:sp>
      <p:pic>
        <p:nvPicPr>
          <p:cNvPr id="10" name="Immagine 9" descr="Immagine che contiene testo, elettronica, schermata, software&#10;&#10;Il contenuto generato dall&amp;#39;IA potrebbe non essere corretto.">
            <a:extLst>
              <a:ext uri="{FF2B5EF4-FFF2-40B4-BE49-F238E27FC236}">
                <a16:creationId xmlns:a16="http://schemas.microsoft.com/office/drawing/2014/main" id="{29FAAED2-12DD-80B6-DDAD-7F0972A502D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0346" t="36011" r="60316" b="27673"/>
          <a:stretch>
            <a:fillRect/>
          </a:stretch>
        </p:blipFill>
        <p:spPr>
          <a:xfrm>
            <a:off x="8089454" y="1211593"/>
            <a:ext cx="1539690" cy="5080263"/>
          </a:xfrm>
          <a:prstGeom prst="rect">
            <a:avLst/>
          </a:prstGeom>
          <a:ln>
            <a:noFill/>
          </a:ln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58C613EA-9ECF-C5A9-7D8E-92028DCF88AC}"/>
              </a:ext>
            </a:extLst>
          </p:cNvPr>
          <p:cNvSpPr txBox="1"/>
          <p:nvPr/>
        </p:nvSpPr>
        <p:spPr>
          <a:xfrm>
            <a:off x="1889760" y="3318401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 err="1"/>
              <a:t>Tubulin</a:t>
            </a:r>
          </a:p>
        </p:txBody>
      </p:sp>
      <p:grpSp>
        <p:nvGrpSpPr>
          <p:cNvPr id="24" name="Gruppo 23">
            <a:extLst>
              <a:ext uri="{FF2B5EF4-FFF2-40B4-BE49-F238E27FC236}">
                <a16:creationId xmlns:a16="http://schemas.microsoft.com/office/drawing/2014/main" id="{E81FB30D-C505-6EEC-2520-DEA3ECF6501C}"/>
              </a:ext>
            </a:extLst>
          </p:cNvPr>
          <p:cNvGrpSpPr/>
          <p:nvPr/>
        </p:nvGrpSpPr>
        <p:grpSpPr>
          <a:xfrm>
            <a:off x="2973776" y="670992"/>
            <a:ext cx="4557160" cy="581540"/>
            <a:chOff x="4441331" y="1207721"/>
            <a:chExt cx="3813520" cy="581540"/>
          </a:xfrm>
        </p:grpSpPr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944C0B38-4980-A134-D818-93E4BB344F06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72F482E0-0614-7BDE-92A7-8BDCB7EF2DB8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7AE3516F-0EC9-F667-DA41-66EC55AC4661}"/>
                </a:ext>
              </a:extLst>
            </p:cNvPr>
            <p:cNvSpPr txBox="1"/>
            <p:nvPr/>
          </p:nvSpPr>
          <p:spPr>
            <a:xfrm>
              <a:off x="5368583" y="1207721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F953339B-D7ED-1C0F-4174-EE156F8C65C5}"/>
                </a:ext>
              </a:extLst>
            </p:cNvPr>
            <p:cNvSpPr txBox="1"/>
            <p:nvPr/>
          </p:nvSpPr>
          <p:spPr>
            <a:xfrm>
              <a:off x="5845982" y="1235263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39C835D0-5897-CA97-B621-4F7D05CBCF7F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6D17054D-EE96-EB76-C59E-2991992C1494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B7CA0B68-6796-909D-CCD7-E7BF86BDDD80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59B40430-729B-BA83-3D69-B405D35B3E18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pic>
        <p:nvPicPr>
          <p:cNvPr id="25" name="Immagine 24" descr="Immagine che contiene bianco e nero, carta, Prodotto di carta, Rettangolo&#10;&#10;Il contenuto generato dall&amp;#39;IA potrebbe non essere corretto.">
            <a:extLst>
              <a:ext uri="{FF2B5EF4-FFF2-40B4-BE49-F238E27FC236}">
                <a16:creationId xmlns:a16="http://schemas.microsoft.com/office/drawing/2014/main" id="{072AD1C6-0E28-4219-83CF-7DBD2F09650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540" t="43934" r="1366" b="-1077"/>
          <a:stretch>
            <a:fillRect/>
          </a:stretch>
        </p:blipFill>
        <p:spPr>
          <a:xfrm>
            <a:off x="2856719" y="3786665"/>
            <a:ext cx="5089070" cy="767433"/>
          </a:xfrm>
          <a:prstGeom prst="rect">
            <a:avLst/>
          </a:prstGeom>
        </p:spPr>
      </p:pic>
      <p:pic>
        <p:nvPicPr>
          <p:cNvPr id="27" name="Immagine 26" descr="Immagine che contiene nero, bianco, bianco e nero, monocromatico&#10;&#10;Il contenuto generato dall&amp;#39;IA potrebbe non essere corretto.">
            <a:extLst>
              <a:ext uri="{FF2B5EF4-FFF2-40B4-BE49-F238E27FC236}">
                <a16:creationId xmlns:a16="http://schemas.microsoft.com/office/drawing/2014/main" id="{E5C395B6-A5AF-E58C-E15F-23DCC9CF4EB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794" t="73987" r="50437" b="6444"/>
          <a:stretch>
            <a:fillRect/>
          </a:stretch>
        </p:blipFill>
        <p:spPr>
          <a:xfrm>
            <a:off x="2974348" y="2352909"/>
            <a:ext cx="4968579" cy="754904"/>
          </a:xfrm>
          <a:prstGeom prst="rect">
            <a:avLst/>
          </a:prstGeom>
        </p:spPr>
      </p:pic>
      <p:pic>
        <p:nvPicPr>
          <p:cNvPr id="3" name="Immagine 2" descr="Immagine che contiene bianco e nero, monocromatico, bianco, nero&#10;&#10;Il contenuto generato dall&amp;#39;IA potrebbe non essere corretto.">
            <a:extLst>
              <a:ext uri="{FF2B5EF4-FFF2-40B4-BE49-F238E27FC236}">
                <a16:creationId xmlns:a16="http://schemas.microsoft.com/office/drawing/2014/main" id="{8C256EC2-46DA-46A4-A50E-D2196B247C60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210" t="45803" r="1100" b="4881"/>
          <a:stretch>
            <a:fillRect/>
          </a:stretch>
        </p:blipFill>
        <p:spPr>
          <a:xfrm>
            <a:off x="2865174" y="3105281"/>
            <a:ext cx="5089836" cy="80325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FBA5C006-30D5-BCF0-B057-7D29FD8358A1}"/>
              </a:ext>
            </a:extLst>
          </p:cNvPr>
          <p:cNvSpPr txBox="1"/>
          <p:nvPr/>
        </p:nvSpPr>
        <p:spPr>
          <a:xfrm>
            <a:off x="8783010" y="6061023"/>
            <a:ext cx="2743200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solidFill>
                  <a:srgbClr val="1C2721"/>
                </a:solidFill>
                <a:latin typeface="Aptos"/>
              </a:rPr>
              <a:t>Precision Plus Protein™ Kaleidoscope™ </a:t>
            </a:r>
            <a:r>
              <a:rPr lang="en-US" sz="1200" dirty="0" err="1">
                <a:solidFill>
                  <a:srgbClr val="1C2721"/>
                </a:solidFill>
                <a:latin typeface="Aptos"/>
              </a:rPr>
              <a:t>Prestained</a:t>
            </a:r>
            <a:r>
              <a:rPr lang="en-US" sz="1200" dirty="0">
                <a:solidFill>
                  <a:srgbClr val="1C2721"/>
                </a:solidFill>
                <a:latin typeface="Aptos"/>
              </a:rPr>
              <a:t> Protein Standards</a:t>
            </a:r>
          </a:p>
        </p:txBody>
      </p:sp>
    </p:spTree>
    <p:extLst>
      <p:ext uri="{BB962C8B-B14F-4D97-AF65-F5344CB8AC3E}">
        <p14:creationId xmlns:p14="http://schemas.microsoft.com/office/powerpoint/2010/main" val="2830260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>
            <a:extLst>
              <a:ext uri="{FF2B5EF4-FFF2-40B4-BE49-F238E27FC236}">
                <a16:creationId xmlns:a16="http://schemas.microsoft.com/office/drawing/2014/main" id="{513FC276-7FF6-36C8-7EAF-8716D1473A6C}"/>
              </a:ext>
            </a:extLst>
          </p:cNvPr>
          <p:cNvGrpSpPr/>
          <p:nvPr/>
        </p:nvGrpSpPr>
        <p:grpSpPr>
          <a:xfrm>
            <a:off x="3855619" y="1500689"/>
            <a:ext cx="4480784" cy="4129297"/>
            <a:chOff x="3855619" y="1500689"/>
            <a:chExt cx="4480784" cy="4129297"/>
          </a:xfrm>
        </p:grpSpPr>
        <p:pic>
          <p:nvPicPr>
            <p:cNvPr id="4" name="Immagine 3" descr="Immagine che contiene schermata, Rettangolo, nero, bian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A78DC85A-1D08-7495-3D91-52B04ACA6E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935" t="43161" r="3564" b="3647"/>
            <a:stretch>
              <a:fillRect/>
            </a:stretch>
          </p:blipFill>
          <p:spPr>
            <a:xfrm>
              <a:off x="3855619" y="3871913"/>
              <a:ext cx="4470795" cy="1758073"/>
            </a:xfrm>
            <a:prstGeom prst="rect">
              <a:avLst/>
            </a:prstGeom>
          </p:spPr>
        </p:pic>
        <p:pic>
          <p:nvPicPr>
            <p:cNvPr id="8" name="Immagine 7" descr="Immagine che contiene nero, bianco e nero, bianc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557EC0CC-DBB1-3730-AFF3-78FF5027C04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1822" b="314"/>
            <a:stretch>
              <a:fillRect/>
            </a:stretch>
          </p:blipFill>
          <p:spPr>
            <a:xfrm>
              <a:off x="3855619" y="1500689"/>
              <a:ext cx="4480784" cy="1585674"/>
            </a:xfrm>
            <a:prstGeom prst="rect">
              <a:avLst/>
            </a:prstGeom>
          </p:spPr>
        </p:pic>
        <p:pic>
          <p:nvPicPr>
            <p:cNvPr id="10" name="Immagine 9" descr="Immagine che contiene Rettangolo, bianco e nero, schermata, bian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336875EC-11A7-33B0-2F0C-EFBECD40FE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5243" t="9503" r="4494" b="65093"/>
            <a:stretch>
              <a:fillRect/>
            </a:stretch>
          </p:blipFill>
          <p:spPr>
            <a:xfrm>
              <a:off x="3865645" y="3084847"/>
              <a:ext cx="4462137" cy="786420"/>
            </a:xfrm>
            <a:prstGeom prst="rect">
              <a:avLst/>
            </a:prstGeom>
          </p:spPr>
        </p:pic>
      </p:grp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C806487-37E1-D301-B1D7-0651940C57EC}"/>
              </a:ext>
            </a:extLst>
          </p:cNvPr>
          <p:cNvSpPr txBox="1"/>
          <p:nvPr/>
        </p:nvSpPr>
        <p:spPr>
          <a:xfrm>
            <a:off x="8388517" y="3096125"/>
            <a:ext cx="11129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SLC7A11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C83134C-DD67-2866-BD28-D63D8685C3AB}"/>
              </a:ext>
            </a:extLst>
          </p:cNvPr>
          <p:cNvSpPr txBox="1"/>
          <p:nvPr/>
        </p:nvSpPr>
        <p:spPr>
          <a:xfrm>
            <a:off x="8543382" y="2296750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err="1"/>
              <a:t>Vinculin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A3982E8F-1336-EE2B-5DAF-F9779CBD3372}"/>
              </a:ext>
            </a:extLst>
          </p:cNvPr>
          <p:cNvSpPr txBox="1"/>
          <p:nvPr/>
        </p:nvSpPr>
        <p:spPr>
          <a:xfrm>
            <a:off x="8699333" y="4600072"/>
            <a:ext cx="11129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GPX4</a:t>
            </a:r>
          </a:p>
        </p:txBody>
      </p: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30C9E029-1876-D306-1297-1C2A8B5DA54B}"/>
              </a:ext>
            </a:extLst>
          </p:cNvPr>
          <p:cNvGrpSpPr/>
          <p:nvPr/>
        </p:nvGrpSpPr>
        <p:grpSpPr>
          <a:xfrm>
            <a:off x="3957293" y="921307"/>
            <a:ext cx="4557160" cy="581540"/>
            <a:chOff x="4441331" y="1207721"/>
            <a:chExt cx="3813520" cy="581540"/>
          </a:xfrm>
        </p:grpSpPr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D8DCB4F8-A77F-303B-23C1-07F0ED857B87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526CF10D-7B7A-D31E-140D-205D978A7C61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2CDD76AE-F601-1980-BA85-8D318F28502F}"/>
                </a:ext>
              </a:extLst>
            </p:cNvPr>
            <p:cNvSpPr txBox="1"/>
            <p:nvPr/>
          </p:nvSpPr>
          <p:spPr>
            <a:xfrm>
              <a:off x="5368583" y="1207721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FEA0EFE3-78C6-CBE0-9AE4-9DC90C9CF615}"/>
                </a:ext>
              </a:extLst>
            </p:cNvPr>
            <p:cNvSpPr txBox="1"/>
            <p:nvPr/>
          </p:nvSpPr>
          <p:spPr>
            <a:xfrm>
              <a:off x="5845982" y="1235263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BE64E19E-2F22-8CC8-1CBC-1925EB36D0F3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AD1CB85E-DC13-BE8E-AAE6-C0B8E57A5EF5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D91FB4F5-8295-62E0-F63C-79661ACB0A3B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0114FB0C-2E28-784B-0AB1-1C3A27208BA6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pic>
        <p:nvPicPr>
          <p:cNvPr id="2" name="Immagine 1">
            <a:extLst>
              <a:ext uri="{FF2B5EF4-FFF2-40B4-BE49-F238E27FC236}">
                <a16:creationId xmlns:a16="http://schemas.microsoft.com/office/drawing/2014/main" id="{62E78C27-45A0-21B9-695A-2D19E4BEA7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0561" y="1600200"/>
            <a:ext cx="1044845" cy="4120856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6132353F-DF68-89D2-0D28-3656DAD9726F}"/>
              </a:ext>
            </a:extLst>
          </p:cNvPr>
          <p:cNvSpPr txBox="1"/>
          <p:nvPr/>
        </p:nvSpPr>
        <p:spPr>
          <a:xfrm>
            <a:off x="1316380" y="5157203"/>
            <a:ext cx="1476261" cy="7886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Protein MW Marker,</a:t>
            </a:r>
            <a:endParaRPr lang="it-IT" dirty="0"/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 Ladder, </a:t>
            </a:r>
            <a:r>
              <a:rPr lang="en-US" sz="1100" dirty="0" err="1">
                <a:solidFill>
                  <a:srgbClr val="333333"/>
                </a:solidFill>
                <a:latin typeface="Aptos"/>
              </a:rPr>
              <a:t>Prestained</a:t>
            </a:r>
            <a:r>
              <a:rPr lang="en-US" sz="1100" dirty="0">
                <a:solidFill>
                  <a:srgbClr val="333333"/>
                </a:solidFill>
                <a:latin typeface="Aptos"/>
              </a:rPr>
              <a:t>, </a:t>
            </a:r>
            <a:endParaRPr lang="en-US" dirty="0">
              <a:solidFill>
                <a:srgbClr val="000000"/>
              </a:solidFill>
              <a:latin typeface="Aptos"/>
            </a:endParaRPr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10-170kD Mark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0446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305771-A6C5-EC5C-65F3-FA85DC542F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o 17">
            <a:extLst>
              <a:ext uri="{FF2B5EF4-FFF2-40B4-BE49-F238E27FC236}">
                <a16:creationId xmlns:a16="http://schemas.microsoft.com/office/drawing/2014/main" id="{66DB88F2-F7F8-4006-C002-9467E41693CD}"/>
              </a:ext>
            </a:extLst>
          </p:cNvPr>
          <p:cNvGrpSpPr/>
          <p:nvPr/>
        </p:nvGrpSpPr>
        <p:grpSpPr>
          <a:xfrm>
            <a:off x="908635" y="2134854"/>
            <a:ext cx="4479878" cy="3082419"/>
            <a:chOff x="3224714" y="2134854"/>
            <a:chExt cx="4479878" cy="3082419"/>
          </a:xfrm>
        </p:grpSpPr>
        <p:pic>
          <p:nvPicPr>
            <p:cNvPr id="2" name="Immagine 1" descr="Immagine che contiene nero, bianco e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8E177AE1-15AF-D0EF-489B-77BB2F8FFA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518" t="8794" r="1518" b="508"/>
            <a:stretch>
              <a:fillRect/>
            </a:stretch>
          </p:blipFill>
          <p:spPr>
            <a:xfrm>
              <a:off x="3224714" y="3429000"/>
              <a:ext cx="4479337" cy="1788273"/>
            </a:xfrm>
            <a:prstGeom prst="rect">
              <a:avLst/>
            </a:prstGeom>
          </p:spPr>
        </p:pic>
        <p:pic>
          <p:nvPicPr>
            <p:cNvPr id="3" name="Immagine 2" descr="Immagine che contiene nero, monocromatico, bianco e nero, plastic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E9EF4BB9-D7F8-D64E-DF04-09DED67D33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3550" t="29952" r="6348" b="7729"/>
            <a:stretch>
              <a:fillRect/>
            </a:stretch>
          </p:blipFill>
          <p:spPr>
            <a:xfrm>
              <a:off x="3224714" y="2134854"/>
              <a:ext cx="4479878" cy="1288085"/>
            </a:xfrm>
            <a:prstGeom prst="rect">
              <a:avLst/>
            </a:prstGeom>
          </p:spPr>
        </p:pic>
      </p:grp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88067AA-9870-F6F8-53F0-5A3E07D257CF}"/>
              </a:ext>
            </a:extLst>
          </p:cNvPr>
          <p:cNvSpPr txBox="1"/>
          <p:nvPr/>
        </p:nvSpPr>
        <p:spPr>
          <a:xfrm>
            <a:off x="5498891" y="2407039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err="1"/>
              <a:t>Vinculin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729ED38-425C-0EAD-5735-938F44B5E69E}"/>
              </a:ext>
            </a:extLst>
          </p:cNvPr>
          <p:cNvSpPr txBox="1"/>
          <p:nvPr/>
        </p:nvSpPr>
        <p:spPr>
          <a:xfrm>
            <a:off x="5494421" y="4321340"/>
            <a:ext cx="1153025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GPX4</a:t>
            </a:r>
          </a:p>
        </p:txBody>
      </p:sp>
      <p:pic>
        <p:nvPicPr>
          <p:cNvPr id="17" name="Immagine 16" descr="Immagine che contiene testo, schermata, software, Icona del computer&#10;&#10;Il contenuto generato dall&amp;#39;IA potrebbe non essere corretto.">
            <a:extLst>
              <a:ext uri="{FF2B5EF4-FFF2-40B4-BE49-F238E27FC236}">
                <a16:creationId xmlns:a16="http://schemas.microsoft.com/office/drawing/2014/main" id="{0726C090-81B0-4FB1-B7D5-B864610C20A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6506" t="34270" r="16717" b="25033"/>
          <a:stretch>
            <a:fillRect/>
          </a:stretch>
        </p:blipFill>
        <p:spPr>
          <a:xfrm>
            <a:off x="141655" y="2124605"/>
            <a:ext cx="760503" cy="3008825"/>
          </a:xfrm>
          <a:prstGeom prst="rect">
            <a:avLst/>
          </a:prstGeom>
        </p:spPr>
      </p:pic>
      <p:pic>
        <p:nvPicPr>
          <p:cNvPr id="20" name="Immagine 19" descr="Immagine che contiene testo, schermata, software, Icona del computer&#10;&#10;Il contenuto generato dall&amp;#39;IA potrebbe non essere corretto.">
            <a:extLst>
              <a:ext uri="{FF2B5EF4-FFF2-40B4-BE49-F238E27FC236}">
                <a16:creationId xmlns:a16="http://schemas.microsoft.com/office/drawing/2014/main" id="{237E1CA9-FA7A-33E3-9738-30A49E7EFF0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6506" t="34270" r="16717" b="25033"/>
          <a:stretch>
            <a:fillRect/>
          </a:stretch>
        </p:blipFill>
        <p:spPr>
          <a:xfrm>
            <a:off x="6488313" y="2094526"/>
            <a:ext cx="760503" cy="3008825"/>
          </a:xfrm>
          <a:prstGeom prst="rect">
            <a:avLst/>
          </a:prstGeom>
        </p:spPr>
      </p:pic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DEDFCF26-D04C-A5D5-3CA3-516E4CB4E23F}"/>
              </a:ext>
            </a:extLst>
          </p:cNvPr>
          <p:cNvSpPr txBox="1"/>
          <p:nvPr/>
        </p:nvSpPr>
        <p:spPr>
          <a:xfrm>
            <a:off x="10943180" y="2407039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PARP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91767308-167C-9554-A200-9227C4795F20}"/>
              </a:ext>
            </a:extLst>
          </p:cNvPr>
          <p:cNvSpPr txBox="1"/>
          <p:nvPr/>
        </p:nvSpPr>
        <p:spPr>
          <a:xfrm>
            <a:off x="10943180" y="3529261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 err="1"/>
              <a:t>Actin</a:t>
            </a:r>
            <a:endParaRPr lang="it-IT"/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33559A06-164E-34B5-003F-06551687CB06}"/>
              </a:ext>
            </a:extLst>
          </p:cNvPr>
          <p:cNvSpPr txBox="1"/>
          <p:nvPr/>
        </p:nvSpPr>
        <p:spPr>
          <a:xfrm>
            <a:off x="10943180" y="3859767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CASP3</a:t>
            </a:r>
          </a:p>
        </p:txBody>
      </p:sp>
      <p:grpSp>
        <p:nvGrpSpPr>
          <p:cNvPr id="36" name="Gruppo 35">
            <a:extLst>
              <a:ext uri="{FF2B5EF4-FFF2-40B4-BE49-F238E27FC236}">
                <a16:creationId xmlns:a16="http://schemas.microsoft.com/office/drawing/2014/main" id="{A046A114-DBD0-B0E4-2366-D44FB6C363F6}"/>
              </a:ext>
            </a:extLst>
          </p:cNvPr>
          <p:cNvGrpSpPr/>
          <p:nvPr/>
        </p:nvGrpSpPr>
        <p:grpSpPr>
          <a:xfrm>
            <a:off x="7481600" y="1051758"/>
            <a:ext cx="4155760" cy="851748"/>
            <a:chOff x="4441331" y="1043663"/>
            <a:chExt cx="4666894" cy="882115"/>
          </a:xfrm>
        </p:grpSpPr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1847F3EC-885B-73DE-FD61-20734107699D}"/>
                </a:ext>
              </a:extLst>
            </p:cNvPr>
            <p:cNvSpPr txBox="1"/>
            <p:nvPr/>
          </p:nvSpPr>
          <p:spPr>
            <a:xfrm>
              <a:off x="7981580" y="1308463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EF84914A-19C7-EC3C-B285-04BCCF4C4E6E}"/>
                </a:ext>
              </a:extLst>
            </p:cNvPr>
            <p:cNvSpPr txBox="1"/>
            <p:nvPr/>
          </p:nvSpPr>
          <p:spPr>
            <a:xfrm>
              <a:off x="8581403" y="1309309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62A070C0-F541-5406-4A3A-D4FECB1D0B4B}"/>
                </a:ext>
              </a:extLst>
            </p:cNvPr>
            <p:cNvSpPr txBox="1"/>
            <p:nvPr/>
          </p:nvSpPr>
          <p:spPr>
            <a:xfrm>
              <a:off x="5678921" y="1043663"/>
              <a:ext cx="526822" cy="882115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BE12A14E-58EB-719A-35E5-4E9233304E74}"/>
                </a:ext>
              </a:extLst>
            </p:cNvPr>
            <p:cNvSpPr txBox="1"/>
            <p:nvPr/>
          </p:nvSpPr>
          <p:spPr>
            <a:xfrm>
              <a:off x="6243851" y="1149965"/>
              <a:ext cx="526822" cy="724595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218ABE10-83B2-0FA9-905D-4DC04B885F73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D9F6D528-B950-ECB7-A972-0032AB711CBD}"/>
                </a:ext>
              </a:extLst>
            </p:cNvPr>
            <p:cNvSpPr txBox="1"/>
            <p:nvPr/>
          </p:nvSpPr>
          <p:spPr>
            <a:xfrm>
              <a:off x="500994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140EFC6A-DA34-5088-0036-D49044F02775}"/>
                </a:ext>
              </a:extLst>
            </p:cNvPr>
            <p:cNvSpPr txBox="1"/>
            <p:nvPr/>
          </p:nvSpPr>
          <p:spPr>
            <a:xfrm>
              <a:off x="7257331" y="1309310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BBA13A59-A138-B98B-3222-6143BF85EB5A}"/>
                </a:ext>
              </a:extLst>
            </p:cNvPr>
            <p:cNvSpPr txBox="1"/>
            <p:nvPr/>
          </p:nvSpPr>
          <p:spPr>
            <a:xfrm>
              <a:off x="6648946" y="1319336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grpSp>
        <p:nvGrpSpPr>
          <p:cNvPr id="46" name="Gruppo 45">
            <a:extLst>
              <a:ext uri="{FF2B5EF4-FFF2-40B4-BE49-F238E27FC236}">
                <a16:creationId xmlns:a16="http://schemas.microsoft.com/office/drawing/2014/main" id="{99CECFF4-1C8D-629E-1480-E460EFCED157}"/>
              </a:ext>
            </a:extLst>
          </p:cNvPr>
          <p:cNvGrpSpPr/>
          <p:nvPr/>
        </p:nvGrpSpPr>
        <p:grpSpPr>
          <a:xfrm>
            <a:off x="1014626" y="1544393"/>
            <a:ext cx="4245999" cy="707886"/>
            <a:chOff x="4441331" y="1130777"/>
            <a:chExt cx="4666894" cy="707886"/>
          </a:xfrm>
        </p:grpSpPr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410441B4-2AB8-AF49-B1DD-6F3DDC4368AA}"/>
                </a:ext>
              </a:extLst>
            </p:cNvPr>
            <p:cNvSpPr txBox="1"/>
            <p:nvPr/>
          </p:nvSpPr>
          <p:spPr>
            <a:xfrm>
              <a:off x="7981580" y="1308463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CB88CC2C-9205-FC4A-46C2-D56AEF22783C}"/>
                </a:ext>
              </a:extLst>
            </p:cNvPr>
            <p:cNvSpPr txBox="1"/>
            <p:nvPr/>
          </p:nvSpPr>
          <p:spPr>
            <a:xfrm>
              <a:off x="8581403" y="1309309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24969F9F-7924-E157-366E-FC1FEA0B14D9}"/>
                </a:ext>
              </a:extLst>
            </p:cNvPr>
            <p:cNvSpPr txBox="1"/>
            <p:nvPr/>
          </p:nvSpPr>
          <p:spPr>
            <a:xfrm>
              <a:off x="5678921" y="1130777"/>
              <a:ext cx="526822" cy="707886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2F6FC5D9-ACA1-A1CB-1FEA-5F93E69796BA}"/>
                </a:ext>
              </a:extLst>
            </p:cNvPr>
            <p:cNvSpPr txBox="1"/>
            <p:nvPr/>
          </p:nvSpPr>
          <p:spPr>
            <a:xfrm>
              <a:off x="6243851" y="1235263"/>
              <a:ext cx="526822" cy="553998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8C21F548-E1BA-CEEF-E7E5-AA39F2011DD2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259F53CE-EF8A-3EAB-BD2E-132D46258BF6}"/>
                </a:ext>
              </a:extLst>
            </p:cNvPr>
            <p:cNvSpPr txBox="1"/>
            <p:nvPr/>
          </p:nvSpPr>
          <p:spPr>
            <a:xfrm>
              <a:off x="500994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8A266F14-0A5A-C54F-90C0-F18F51CD2773}"/>
                </a:ext>
              </a:extLst>
            </p:cNvPr>
            <p:cNvSpPr txBox="1"/>
            <p:nvPr/>
          </p:nvSpPr>
          <p:spPr>
            <a:xfrm>
              <a:off x="7257331" y="1309310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736D8362-D599-AE51-0658-E30B0478EB35}"/>
                </a:ext>
              </a:extLst>
            </p:cNvPr>
            <p:cNvSpPr txBox="1"/>
            <p:nvPr/>
          </p:nvSpPr>
          <p:spPr>
            <a:xfrm>
              <a:off x="6648946" y="1319336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grpSp>
        <p:nvGrpSpPr>
          <p:cNvPr id="8" name="Gruppo 7">
            <a:extLst>
              <a:ext uri="{FF2B5EF4-FFF2-40B4-BE49-F238E27FC236}">
                <a16:creationId xmlns:a16="http://schemas.microsoft.com/office/drawing/2014/main" id="{EFAC08F5-83B2-FEF5-A557-0F94E27905AD}"/>
              </a:ext>
            </a:extLst>
          </p:cNvPr>
          <p:cNvGrpSpPr/>
          <p:nvPr/>
        </p:nvGrpSpPr>
        <p:grpSpPr>
          <a:xfrm>
            <a:off x="7250034" y="2088982"/>
            <a:ext cx="3615177" cy="2947870"/>
            <a:chOff x="7250034" y="2088982"/>
            <a:chExt cx="3615177" cy="2947870"/>
          </a:xfrm>
        </p:grpSpPr>
        <p:pic>
          <p:nvPicPr>
            <p:cNvPr id="21" name="Immagine 20" descr="Immagine che contiene nero, monocromatico, bianco e nero, Fotografia monocromatic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8DFB3DA2-6F26-FC7D-6D57-BE0283DD9C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4347" t="14569" r="5276" b="948"/>
            <a:stretch>
              <a:fillRect/>
            </a:stretch>
          </p:blipFill>
          <p:spPr>
            <a:xfrm>
              <a:off x="7253289" y="2088982"/>
              <a:ext cx="3604638" cy="1475730"/>
            </a:xfrm>
            <a:prstGeom prst="rect">
              <a:avLst/>
            </a:prstGeom>
          </p:spPr>
        </p:pic>
        <p:pic>
          <p:nvPicPr>
            <p:cNvPr id="22" name="Immagine 21" descr="Immagine che contiene schermata, bianco e nero, ner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19670EDA-47B6-7B94-3675-4880B480288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8320" t="20465" r="4709" b="35814"/>
            <a:stretch>
              <a:fillRect/>
            </a:stretch>
          </p:blipFill>
          <p:spPr>
            <a:xfrm>
              <a:off x="7251784" y="3571123"/>
              <a:ext cx="3613427" cy="574348"/>
            </a:xfrm>
            <a:prstGeom prst="rect">
              <a:avLst/>
            </a:prstGeom>
          </p:spPr>
        </p:pic>
        <p:pic>
          <p:nvPicPr>
            <p:cNvPr id="6" name="Immagine 5" descr="Immagine che contiene bianco e nero, ner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3706903D-DD9F-AFF8-17D4-6E088DEB4FF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5692" t="34953" r="5889" b="50747"/>
            <a:stretch>
              <a:fillRect/>
            </a:stretch>
          </p:blipFill>
          <p:spPr>
            <a:xfrm>
              <a:off x="7250034" y="3862094"/>
              <a:ext cx="3613030" cy="288733"/>
            </a:xfrm>
            <a:prstGeom prst="rect">
              <a:avLst/>
            </a:prstGeom>
          </p:spPr>
        </p:pic>
        <p:pic>
          <p:nvPicPr>
            <p:cNvPr id="7" name="Immagine 6" descr="Immagine che contiene nero, Rettangolo, Fotografia monocromatica, schermat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43C36E75-DF5B-09C5-0BE4-7204D61E1DC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7014" t="42343" r="8519" b="15837"/>
            <a:stretch>
              <a:fillRect/>
            </a:stretch>
          </p:blipFill>
          <p:spPr>
            <a:xfrm>
              <a:off x="7257189" y="4170042"/>
              <a:ext cx="3603638" cy="866810"/>
            </a:xfrm>
            <a:prstGeom prst="rect">
              <a:avLst/>
            </a:prstGeom>
          </p:spPr>
        </p:pic>
      </p:grp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B123813D-F0CC-5369-3CF2-033C07A0AC03}"/>
              </a:ext>
            </a:extLst>
          </p:cNvPr>
          <p:cNvSpPr txBox="1"/>
          <p:nvPr/>
        </p:nvSpPr>
        <p:spPr>
          <a:xfrm>
            <a:off x="0" y="5329568"/>
            <a:ext cx="1476261" cy="7886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Protein MW Marker,</a:t>
            </a:r>
            <a:endParaRPr lang="it-IT" dirty="0"/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 Ladder, </a:t>
            </a:r>
            <a:r>
              <a:rPr lang="en-US" sz="1100" dirty="0" err="1">
                <a:solidFill>
                  <a:srgbClr val="333333"/>
                </a:solidFill>
                <a:latin typeface="Aptos"/>
              </a:rPr>
              <a:t>Prestained</a:t>
            </a:r>
            <a:r>
              <a:rPr lang="en-US" sz="1100" dirty="0">
                <a:solidFill>
                  <a:srgbClr val="333333"/>
                </a:solidFill>
                <a:latin typeface="Aptos"/>
              </a:rPr>
              <a:t>, </a:t>
            </a:r>
            <a:endParaRPr lang="en-US" dirty="0">
              <a:solidFill>
                <a:srgbClr val="000000"/>
              </a:solidFill>
              <a:latin typeface="Aptos"/>
            </a:endParaRPr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10-170kD Marker</a:t>
            </a:r>
            <a:endParaRPr lang="en-US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6C2F8E5-198A-3016-03E4-51FCD7FC5384}"/>
              </a:ext>
            </a:extLst>
          </p:cNvPr>
          <p:cNvSpPr txBox="1"/>
          <p:nvPr/>
        </p:nvSpPr>
        <p:spPr>
          <a:xfrm>
            <a:off x="6259064" y="5217273"/>
            <a:ext cx="1476261" cy="7886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Protein MW Marker,</a:t>
            </a:r>
            <a:endParaRPr lang="it-IT" dirty="0"/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 Ladder, </a:t>
            </a:r>
            <a:r>
              <a:rPr lang="en-US" sz="1100" dirty="0" err="1">
                <a:solidFill>
                  <a:srgbClr val="333333"/>
                </a:solidFill>
                <a:latin typeface="Aptos"/>
              </a:rPr>
              <a:t>Prestained</a:t>
            </a:r>
            <a:r>
              <a:rPr lang="en-US" sz="1100" dirty="0">
                <a:solidFill>
                  <a:srgbClr val="333333"/>
                </a:solidFill>
                <a:latin typeface="Aptos"/>
              </a:rPr>
              <a:t>, </a:t>
            </a:r>
            <a:endParaRPr lang="en-US" dirty="0">
              <a:solidFill>
                <a:srgbClr val="000000"/>
              </a:solidFill>
              <a:latin typeface="Aptos"/>
            </a:endParaRPr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10-170kD Mark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09181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08670D-445A-149A-8AD8-4F4086767D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>
            <a:extLst>
              <a:ext uri="{FF2B5EF4-FFF2-40B4-BE49-F238E27FC236}">
                <a16:creationId xmlns:a16="http://schemas.microsoft.com/office/drawing/2014/main" id="{15473A0B-E50D-A053-56F9-7E7CA340B20D}"/>
              </a:ext>
            </a:extLst>
          </p:cNvPr>
          <p:cNvSpPr txBox="1"/>
          <p:nvPr/>
        </p:nvSpPr>
        <p:spPr>
          <a:xfrm>
            <a:off x="8001000" y="3059668"/>
            <a:ext cx="11129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dirty="0"/>
              <a:t>SLC7A11</a:t>
            </a:r>
          </a:p>
        </p:txBody>
      </p:sp>
      <p:grpSp>
        <p:nvGrpSpPr>
          <p:cNvPr id="10" name="Gruppo 9">
            <a:extLst>
              <a:ext uri="{FF2B5EF4-FFF2-40B4-BE49-F238E27FC236}">
                <a16:creationId xmlns:a16="http://schemas.microsoft.com/office/drawing/2014/main" id="{7783A039-8E2F-9257-3F88-D4EA4E787AB7}"/>
              </a:ext>
            </a:extLst>
          </p:cNvPr>
          <p:cNvGrpSpPr/>
          <p:nvPr/>
        </p:nvGrpSpPr>
        <p:grpSpPr>
          <a:xfrm>
            <a:off x="3695699" y="1508957"/>
            <a:ext cx="4264268" cy="4158481"/>
            <a:chOff x="3373855" y="2135965"/>
            <a:chExt cx="4996188" cy="4399112"/>
          </a:xfrm>
        </p:grpSpPr>
        <p:pic>
          <p:nvPicPr>
            <p:cNvPr id="2" name="Immagine 1" descr="Immagine che contiene bianco e nero, bianc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9AA41F78-DB62-A68B-6E39-7A8DE30FA51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438" t="3460" r="5680" b="7612"/>
            <a:stretch>
              <a:fillRect/>
            </a:stretch>
          </p:blipFill>
          <p:spPr>
            <a:xfrm>
              <a:off x="3380122" y="3721018"/>
              <a:ext cx="4989921" cy="2814059"/>
            </a:xfrm>
            <a:prstGeom prst="rect">
              <a:avLst/>
            </a:prstGeom>
          </p:spPr>
        </p:pic>
        <p:pic>
          <p:nvPicPr>
            <p:cNvPr id="3" name="Immagine 2" descr="Immagine che contiene schermata, nero, monocromatico, Fotografia monocromatic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7CC29F82-E169-D6DE-C6F3-E14694A79E1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4428" t="10215" r="5620" b="7016"/>
            <a:stretch>
              <a:fillRect/>
            </a:stretch>
          </p:blipFill>
          <p:spPr>
            <a:xfrm>
              <a:off x="3373855" y="2135965"/>
              <a:ext cx="4994414" cy="1584640"/>
            </a:xfrm>
            <a:prstGeom prst="rect">
              <a:avLst/>
            </a:prstGeom>
          </p:spPr>
        </p:pic>
      </p:grp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BF19ECC-12D0-8FE2-6F67-429CD8046541}"/>
              </a:ext>
            </a:extLst>
          </p:cNvPr>
          <p:cNvSpPr txBox="1"/>
          <p:nvPr/>
        </p:nvSpPr>
        <p:spPr>
          <a:xfrm>
            <a:off x="8025523" y="2228208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err="1"/>
              <a:t>Vinculin</a:t>
            </a:r>
          </a:p>
        </p:txBody>
      </p: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4437A2B5-0179-E0A2-BF1D-9599C6963D1B}"/>
              </a:ext>
            </a:extLst>
          </p:cNvPr>
          <p:cNvGrpSpPr/>
          <p:nvPr/>
        </p:nvGrpSpPr>
        <p:grpSpPr>
          <a:xfrm>
            <a:off x="3270948" y="980430"/>
            <a:ext cx="4805038" cy="427654"/>
            <a:chOff x="4441331" y="1284663"/>
            <a:chExt cx="3813520" cy="427654"/>
          </a:xfrm>
        </p:grpSpPr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8F8E49B5-4610-BE30-70D4-2C180602CBD3}"/>
                </a:ext>
              </a:extLst>
            </p:cNvPr>
            <p:cNvSpPr txBox="1"/>
            <p:nvPr/>
          </p:nvSpPr>
          <p:spPr>
            <a:xfrm>
              <a:off x="6286656" y="129843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dirty="0" err="1"/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980EBD0F-4C43-DAE0-4682-AF129E87043A}"/>
                </a:ext>
              </a:extLst>
            </p:cNvPr>
            <p:cNvSpPr txBox="1"/>
            <p:nvPr/>
          </p:nvSpPr>
          <p:spPr>
            <a:xfrm>
              <a:off x="6727331" y="128925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AGS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80640D68-DD13-CA08-F3C9-6C57EA6E69F3}"/>
                </a:ext>
              </a:extLst>
            </p:cNvPr>
            <p:cNvSpPr txBox="1"/>
            <p:nvPr/>
          </p:nvSpPr>
          <p:spPr>
            <a:xfrm>
              <a:off x="5368583" y="1284665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N87</a:t>
              </a:r>
            </a:p>
            <a:p>
              <a:pPr algn="ctr"/>
              <a:r>
                <a:rPr lang="it-IT" sz="1000" dirty="0" err="1"/>
                <a:t>Vehicle</a:t>
              </a:r>
              <a:endParaRPr lang="it-IT" sz="1000"/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C16A8864-DA6B-820C-F730-CBD046FA0D4C}"/>
                </a:ext>
              </a:extLst>
            </p:cNvPr>
            <p:cNvSpPr txBox="1"/>
            <p:nvPr/>
          </p:nvSpPr>
          <p:spPr>
            <a:xfrm>
              <a:off x="5845982" y="1312207"/>
              <a:ext cx="52682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NCI-87</a:t>
              </a:r>
            </a:p>
            <a:p>
              <a:pPr algn="ctr"/>
              <a:r>
                <a:rPr lang="it-IT" sz="1000" dirty="0"/>
                <a:t>Sal</a:t>
              </a:r>
              <a:endParaRPr lang="it-IT" dirty="0"/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D7F551C4-4FC8-302B-C36C-CBD29E911A98}"/>
                </a:ext>
              </a:extLst>
            </p:cNvPr>
            <p:cNvSpPr txBox="1"/>
            <p:nvPr/>
          </p:nvSpPr>
          <p:spPr>
            <a:xfrm>
              <a:off x="4441331" y="1284663"/>
              <a:ext cx="719616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1C10830D-D66A-75B6-C4E8-FCB88841D1D0}"/>
                </a:ext>
              </a:extLst>
            </p:cNvPr>
            <p:cNvSpPr txBox="1"/>
            <p:nvPr/>
          </p:nvSpPr>
          <p:spPr>
            <a:xfrm>
              <a:off x="4826921" y="1289255"/>
              <a:ext cx="719617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SNU1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59D26E08-41B7-6871-2910-EA51464403FE}"/>
                </a:ext>
              </a:extLst>
            </p:cNvPr>
            <p:cNvSpPr txBox="1"/>
            <p:nvPr/>
          </p:nvSpPr>
          <p:spPr>
            <a:xfrm>
              <a:off x="759949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/>
                <a:t>Sal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5C983916-9784-33BC-9063-B116FD172C7C}"/>
                </a:ext>
              </a:extLst>
            </p:cNvPr>
            <p:cNvSpPr txBox="1"/>
            <p:nvPr/>
          </p:nvSpPr>
          <p:spPr>
            <a:xfrm>
              <a:off x="7094559" y="1289257"/>
              <a:ext cx="655352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000" dirty="0"/>
                <a:t>KATO III</a:t>
              </a:r>
            </a:p>
            <a:p>
              <a:pPr algn="ctr"/>
              <a:r>
                <a:rPr lang="it-IT" sz="1000" dirty="0" err="1"/>
                <a:t>Vehicle</a:t>
              </a:r>
            </a:p>
          </p:txBody>
        </p:sp>
      </p:grpSp>
      <p:pic>
        <p:nvPicPr>
          <p:cNvPr id="4" name="Immagine 3" descr="Immagine che contiene testo, schermata, software, Icona del computer&#10;&#10;Il contenuto generato dall&amp;#39;IA potrebbe non essere corretto.">
            <a:extLst>
              <a:ext uri="{FF2B5EF4-FFF2-40B4-BE49-F238E27FC236}">
                <a16:creationId xmlns:a16="http://schemas.microsoft.com/office/drawing/2014/main" id="{0709AFC5-569B-BDA1-BEF0-F88DC666890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6506" t="34270" r="16717" b="25033"/>
          <a:stretch>
            <a:fillRect/>
          </a:stretch>
        </p:blipFill>
        <p:spPr>
          <a:xfrm>
            <a:off x="2884089" y="2057924"/>
            <a:ext cx="760503" cy="3008825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7EAD971A-98DE-E014-D145-43467282FF44}"/>
              </a:ext>
            </a:extLst>
          </p:cNvPr>
          <p:cNvSpPr txBox="1"/>
          <p:nvPr/>
        </p:nvSpPr>
        <p:spPr>
          <a:xfrm>
            <a:off x="2320443" y="5088924"/>
            <a:ext cx="1476261" cy="7886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Protein MW Marker,</a:t>
            </a:r>
            <a:endParaRPr lang="it-IT" dirty="0"/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 Ladder, </a:t>
            </a:r>
            <a:r>
              <a:rPr lang="en-US" sz="1100" dirty="0" err="1">
                <a:solidFill>
                  <a:srgbClr val="333333"/>
                </a:solidFill>
                <a:latin typeface="Aptos"/>
              </a:rPr>
              <a:t>Prestained</a:t>
            </a:r>
            <a:r>
              <a:rPr lang="en-US" sz="1100" dirty="0">
                <a:solidFill>
                  <a:srgbClr val="333333"/>
                </a:solidFill>
                <a:latin typeface="Aptos"/>
              </a:rPr>
              <a:t>, </a:t>
            </a:r>
            <a:endParaRPr lang="en-US" dirty="0">
              <a:solidFill>
                <a:srgbClr val="000000"/>
              </a:solidFill>
              <a:latin typeface="Aptos"/>
            </a:endParaRPr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10-170kD Mark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44466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nero, bianco e nero, schermata, monocromatico&#10;&#10;Il contenuto generato dall&amp;#39;IA potrebbe non essere corretto.">
            <a:extLst>
              <a:ext uri="{FF2B5EF4-FFF2-40B4-BE49-F238E27FC236}">
                <a16:creationId xmlns:a16="http://schemas.microsoft.com/office/drawing/2014/main" id="{E5963CBE-2366-FB60-7E39-850CBB96666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05" t="5069" r="448" b="10433"/>
          <a:stretch>
            <a:fillRect/>
          </a:stretch>
        </p:blipFill>
        <p:spPr>
          <a:xfrm>
            <a:off x="4097494" y="3686787"/>
            <a:ext cx="2676440" cy="640351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35C72EE-5A6D-5E31-99B2-E813487F588A}"/>
              </a:ext>
            </a:extLst>
          </p:cNvPr>
          <p:cNvSpPr txBox="1"/>
          <p:nvPr/>
        </p:nvSpPr>
        <p:spPr>
          <a:xfrm>
            <a:off x="2769127" y="2789915"/>
            <a:ext cx="153594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PARP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505D5EB9-5D7D-B48C-D74C-B21CEF9A4B69}"/>
              </a:ext>
            </a:extLst>
          </p:cNvPr>
          <p:cNvSpPr txBox="1"/>
          <p:nvPr/>
        </p:nvSpPr>
        <p:spPr>
          <a:xfrm>
            <a:off x="2608705" y="4567834"/>
            <a:ext cx="175628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/>
              <a:t>CASP 3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B7CAF761-646B-BDC4-64C7-ABF0A6A19321}"/>
              </a:ext>
            </a:extLst>
          </p:cNvPr>
          <p:cNvSpPr txBox="1"/>
          <p:nvPr/>
        </p:nvSpPr>
        <p:spPr>
          <a:xfrm>
            <a:off x="2608704" y="5405574"/>
            <a:ext cx="994283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LC3A/B</a:t>
            </a:r>
          </a:p>
          <a:p>
            <a:endParaRPr lang="it-IT" dirty="0"/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CFC347EA-1B28-8806-7CF6-F9FD1A55CD20}"/>
              </a:ext>
            </a:extLst>
          </p:cNvPr>
          <p:cNvGrpSpPr/>
          <p:nvPr/>
        </p:nvGrpSpPr>
        <p:grpSpPr>
          <a:xfrm>
            <a:off x="4179795" y="630290"/>
            <a:ext cx="2592484" cy="738664"/>
            <a:chOff x="5065620" y="449785"/>
            <a:chExt cx="2592484" cy="738664"/>
          </a:xfrm>
        </p:grpSpPr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06834875-6014-C3B8-72B6-FA007B9A5221}"/>
                </a:ext>
              </a:extLst>
            </p:cNvPr>
            <p:cNvSpPr txBox="1"/>
            <p:nvPr/>
          </p:nvSpPr>
          <p:spPr>
            <a:xfrm>
              <a:off x="5065620" y="562098"/>
              <a:ext cx="820604" cy="52322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400" dirty="0"/>
                <a:t>AGS</a:t>
              </a:r>
              <a:endParaRPr lang="it-IT" dirty="0"/>
            </a:p>
            <a:p>
              <a:pPr algn="ctr"/>
              <a:r>
                <a:rPr lang="it-IT" sz="1400" dirty="0" err="1"/>
                <a:t>Vehicle</a:t>
              </a:r>
              <a:endParaRPr lang="it-IT" dirty="0" err="1"/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30496C69-3B05-A406-473A-6026543D6E3F}"/>
                </a:ext>
              </a:extLst>
            </p:cNvPr>
            <p:cNvSpPr txBox="1"/>
            <p:nvPr/>
          </p:nvSpPr>
          <p:spPr>
            <a:xfrm>
              <a:off x="5744993" y="566688"/>
              <a:ext cx="701255" cy="52322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400" dirty="0"/>
                <a:t>AGS</a:t>
              </a:r>
              <a:endParaRPr lang="it-IT" dirty="0"/>
            </a:p>
            <a:p>
              <a:pPr algn="ctr"/>
              <a:r>
                <a:rPr lang="it-IT" sz="1400" dirty="0"/>
                <a:t>Sal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ABA52B2E-2135-C401-F525-8958736882CF}"/>
                </a:ext>
              </a:extLst>
            </p:cNvPr>
            <p:cNvSpPr txBox="1"/>
            <p:nvPr/>
          </p:nvSpPr>
          <p:spPr>
            <a:xfrm>
              <a:off x="6277475" y="449785"/>
              <a:ext cx="811424" cy="7386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400" dirty="0"/>
                <a:t>NCI-N87</a:t>
              </a:r>
              <a:endParaRPr lang="it-IT" dirty="0"/>
            </a:p>
            <a:p>
              <a:pPr algn="ctr"/>
              <a:r>
                <a:rPr lang="it-IT" sz="1400" dirty="0" err="1"/>
                <a:t>Vehicle</a:t>
              </a:r>
              <a:endParaRPr lang="it-IT" dirty="0" err="1"/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FC255B3F-8546-D411-719B-4FC6BAB48DC4}"/>
                </a:ext>
              </a:extLst>
            </p:cNvPr>
            <p:cNvSpPr txBox="1"/>
            <p:nvPr/>
          </p:nvSpPr>
          <p:spPr>
            <a:xfrm>
              <a:off x="6956849" y="449785"/>
              <a:ext cx="701255" cy="738664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it-IT" sz="1400" dirty="0"/>
                <a:t>NCI-N87</a:t>
              </a:r>
              <a:endParaRPr lang="it-IT" dirty="0"/>
            </a:p>
            <a:p>
              <a:pPr algn="ctr"/>
              <a:r>
                <a:rPr lang="it-IT" sz="1400" dirty="0"/>
                <a:t>Sal</a:t>
              </a:r>
            </a:p>
          </p:txBody>
        </p:sp>
      </p:grpSp>
      <p:pic>
        <p:nvPicPr>
          <p:cNvPr id="7" name="Immagine 6" descr="Immagine che contiene testo, elettronica, schermata, software&#10;&#10;Il contenuto generato dall&amp;#39;IA potrebbe non essere corretto.">
            <a:extLst>
              <a:ext uri="{FF2B5EF4-FFF2-40B4-BE49-F238E27FC236}">
                <a16:creationId xmlns:a16="http://schemas.microsoft.com/office/drawing/2014/main" id="{958D3810-FE89-D1A0-C47A-9409655ED76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0346" t="36011" r="60316" b="27673"/>
          <a:stretch>
            <a:fillRect/>
          </a:stretch>
        </p:blipFill>
        <p:spPr>
          <a:xfrm>
            <a:off x="7052963" y="1669159"/>
            <a:ext cx="1552999" cy="4676775"/>
          </a:xfrm>
          <a:prstGeom prst="rect">
            <a:avLst/>
          </a:prstGeom>
          <a:ln>
            <a:noFill/>
          </a:ln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22DCDFE4-B8DD-BEC9-2FC2-38076C1BEC1B}"/>
              </a:ext>
            </a:extLst>
          </p:cNvPr>
          <p:cNvSpPr txBox="1"/>
          <p:nvPr/>
        </p:nvSpPr>
        <p:spPr>
          <a:xfrm>
            <a:off x="8747000" y="5674636"/>
            <a:ext cx="1953659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>
                <a:solidFill>
                  <a:srgbClr val="1C2721"/>
                </a:solidFill>
                <a:latin typeface="Aptos"/>
              </a:rPr>
              <a:t>Precision Plus Protein™ Kaleidoscope™ </a:t>
            </a:r>
            <a:r>
              <a:rPr lang="en-US" sz="1200" err="1">
                <a:solidFill>
                  <a:srgbClr val="1C2721"/>
                </a:solidFill>
                <a:latin typeface="Aptos"/>
              </a:rPr>
              <a:t>Prestained</a:t>
            </a:r>
            <a:r>
              <a:rPr lang="en-US" sz="1200">
                <a:solidFill>
                  <a:srgbClr val="1C2721"/>
                </a:solidFill>
                <a:latin typeface="Aptos"/>
              </a:rPr>
              <a:t> Protein Standards</a:t>
            </a:r>
          </a:p>
        </p:txBody>
      </p:sp>
      <p:pic>
        <p:nvPicPr>
          <p:cNvPr id="9" name="Immagine 8" descr="Immagine che contiene bianco e nero, nero, monocromatico, bianco&#10;&#10;Il contenuto generato dall&amp;#39;IA potrebbe non essere corretto.">
            <a:extLst>
              <a:ext uri="{FF2B5EF4-FFF2-40B4-BE49-F238E27FC236}">
                <a16:creationId xmlns:a16="http://schemas.microsoft.com/office/drawing/2014/main" id="{2BEC8570-7869-A7F8-8C52-A35F8A4A530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028" t="34145" r="10349" b="37360"/>
          <a:stretch>
            <a:fillRect/>
          </a:stretch>
        </p:blipFill>
        <p:spPr>
          <a:xfrm>
            <a:off x="3795158" y="3401129"/>
            <a:ext cx="3190978" cy="367523"/>
          </a:xfrm>
          <a:prstGeom prst="rect">
            <a:avLst/>
          </a:prstGeom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4994F9FF-6D2F-635F-1433-2F4E13608C6A}"/>
              </a:ext>
            </a:extLst>
          </p:cNvPr>
          <p:cNvSpPr txBox="1"/>
          <p:nvPr/>
        </p:nvSpPr>
        <p:spPr>
          <a:xfrm>
            <a:off x="2718995" y="3928928"/>
            <a:ext cx="1535946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err="1"/>
              <a:t>Actin</a:t>
            </a:r>
          </a:p>
          <a:p>
            <a:endParaRPr lang="it-IT"/>
          </a:p>
        </p:txBody>
      </p:sp>
      <p:pic>
        <p:nvPicPr>
          <p:cNvPr id="5" name="Immagine 4" descr="Immagine che contiene bianco e nero, bianco, schermata, nero&#10;&#10;Il contenuto generato dall&amp;#39;IA potrebbe non essere corretto.">
            <a:extLst>
              <a:ext uri="{FF2B5EF4-FFF2-40B4-BE49-F238E27FC236}">
                <a16:creationId xmlns:a16="http://schemas.microsoft.com/office/drawing/2014/main" id="{CD1C94A1-BC74-7BD2-4A91-8EFFF9177CB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-138" t="47644" r="2656" b="5759"/>
          <a:stretch>
            <a:fillRect/>
          </a:stretch>
        </p:blipFill>
        <p:spPr>
          <a:xfrm>
            <a:off x="3795573" y="4936101"/>
            <a:ext cx="3188854" cy="816066"/>
          </a:xfrm>
          <a:prstGeom prst="rect">
            <a:avLst/>
          </a:prstGeom>
        </p:spPr>
      </p:pic>
      <p:pic>
        <p:nvPicPr>
          <p:cNvPr id="11" name="Immagine 10" descr="Immagine che contiene nero, monocromatico, bianco e nero, Fotografia monocromatica&#10;&#10;Il contenuto generato dall&amp;#39;IA potrebbe non essere corretto.">
            <a:extLst>
              <a:ext uri="{FF2B5EF4-FFF2-40B4-BE49-F238E27FC236}">
                <a16:creationId xmlns:a16="http://schemas.microsoft.com/office/drawing/2014/main" id="{2EC22019-B3DD-641A-8433-8402C7A4C84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478" t="14167" r="4058" b="3616"/>
          <a:stretch>
            <a:fillRect/>
          </a:stretch>
        </p:blipFill>
        <p:spPr>
          <a:xfrm>
            <a:off x="3784981" y="1426551"/>
            <a:ext cx="3193910" cy="1977304"/>
          </a:xfrm>
          <a:prstGeom prst="rect">
            <a:avLst/>
          </a:prstGeom>
        </p:spPr>
      </p:pic>
      <p:pic>
        <p:nvPicPr>
          <p:cNvPr id="13" name="Immagine 12" descr="Immagine che contiene nero, monocromatico, Fotografia monocromatica, bianco e nero&#10;&#10;Il contenuto generato dall&amp;#39;IA potrebbe non essere corretto.">
            <a:extLst>
              <a:ext uri="{FF2B5EF4-FFF2-40B4-BE49-F238E27FC236}">
                <a16:creationId xmlns:a16="http://schemas.microsoft.com/office/drawing/2014/main" id="{44EA0B2A-B928-FBD3-796E-A6CE6BCED7C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1603" t="29960" r="3902" b="43320"/>
          <a:stretch>
            <a:fillRect/>
          </a:stretch>
        </p:blipFill>
        <p:spPr>
          <a:xfrm>
            <a:off x="4094085" y="4328298"/>
            <a:ext cx="2680021" cy="605761"/>
          </a:xfrm>
          <a:prstGeom prst="rect">
            <a:avLst/>
          </a:prstGeom>
        </p:spPr>
      </p:pic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E90B29F2-EE6B-673F-3013-F0D06DB5EED6}"/>
              </a:ext>
            </a:extLst>
          </p:cNvPr>
          <p:cNvSpPr txBox="1"/>
          <p:nvPr/>
        </p:nvSpPr>
        <p:spPr>
          <a:xfrm>
            <a:off x="2287081" y="3403664"/>
            <a:ext cx="150551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SQSTM1/p62</a:t>
            </a:r>
          </a:p>
        </p:txBody>
      </p:sp>
    </p:spTree>
    <p:extLst>
      <p:ext uri="{BB962C8B-B14F-4D97-AF65-F5344CB8AC3E}">
        <p14:creationId xmlns:p14="http://schemas.microsoft.com/office/powerpoint/2010/main" val="30167823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3C92955F-A14F-0A32-1DA4-92DA2DB3FCDF}"/>
              </a:ext>
            </a:extLst>
          </p:cNvPr>
          <p:cNvSpPr txBox="1"/>
          <p:nvPr/>
        </p:nvSpPr>
        <p:spPr>
          <a:xfrm>
            <a:off x="5355166" y="4704461"/>
            <a:ext cx="175628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LC3A/B 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DA11408F-8FDC-28B7-BA2F-D9237BA1B10C}"/>
              </a:ext>
            </a:extLst>
          </p:cNvPr>
          <p:cNvSpPr txBox="1"/>
          <p:nvPr/>
        </p:nvSpPr>
        <p:spPr>
          <a:xfrm>
            <a:off x="5355168" y="2060416"/>
            <a:ext cx="153594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PARP </a:t>
            </a:r>
          </a:p>
        </p:txBody>
      </p:sp>
      <p:pic>
        <p:nvPicPr>
          <p:cNvPr id="3" name="Immagine 2" descr="Immagine che contiene testo, schermata, software, Icona del computer&#10;&#10;Il contenuto generato dall&amp;#39;IA potrebbe non essere corretto.">
            <a:extLst>
              <a:ext uri="{FF2B5EF4-FFF2-40B4-BE49-F238E27FC236}">
                <a16:creationId xmlns:a16="http://schemas.microsoft.com/office/drawing/2014/main" id="{ED877A13-E6ED-25CE-E832-67758C39770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6506" t="34270" r="16717" b="25033"/>
          <a:stretch>
            <a:fillRect/>
          </a:stretch>
        </p:blipFill>
        <p:spPr>
          <a:xfrm>
            <a:off x="2480294" y="1524029"/>
            <a:ext cx="1031213" cy="4121745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58E9776-5B3E-0919-A2CC-67EEA0B82BE0}"/>
              </a:ext>
            </a:extLst>
          </p:cNvPr>
          <p:cNvSpPr txBox="1"/>
          <p:nvPr/>
        </p:nvSpPr>
        <p:spPr>
          <a:xfrm>
            <a:off x="1945030" y="5645774"/>
            <a:ext cx="1476261" cy="7886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Protein MW Marker,</a:t>
            </a:r>
            <a:endParaRPr lang="it-IT" dirty="0"/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 Ladder, </a:t>
            </a:r>
            <a:r>
              <a:rPr lang="en-US" sz="1100" dirty="0" err="1">
                <a:solidFill>
                  <a:srgbClr val="333333"/>
                </a:solidFill>
                <a:latin typeface="Aptos"/>
              </a:rPr>
              <a:t>Prestained</a:t>
            </a:r>
            <a:r>
              <a:rPr lang="en-US" sz="1100" dirty="0">
                <a:solidFill>
                  <a:srgbClr val="333333"/>
                </a:solidFill>
                <a:latin typeface="Aptos"/>
              </a:rPr>
              <a:t>, </a:t>
            </a:r>
            <a:endParaRPr lang="en-US" dirty="0">
              <a:solidFill>
                <a:srgbClr val="000000"/>
              </a:solidFill>
              <a:latin typeface="Aptos"/>
            </a:endParaRPr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10-170kD Marker</a:t>
            </a:r>
            <a:endParaRPr lang="en-US" dirty="0"/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715E78C9-F6E4-DABB-094E-EEE8DAFA1981}"/>
              </a:ext>
            </a:extLst>
          </p:cNvPr>
          <p:cNvSpPr txBox="1"/>
          <p:nvPr/>
        </p:nvSpPr>
        <p:spPr>
          <a:xfrm>
            <a:off x="9130924" y="1946832"/>
            <a:ext cx="109190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err="1"/>
              <a:t>Vinculin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71785D14-56E9-39BD-C187-88D5276D20AC}"/>
              </a:ext>
            </a:extLst>
          </p:cNvPr>
          <p:cNvSpPr txBox="1"/>
          <p:nvPr/>
        </p:nvSpPr>
        <p:spPr>
          <a:xfrm>
            <a:off x="5388329" y="3496682"/>
            <a:ext cx="73385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it-IT" err="1"/>
              <a:t>Actin</a:t>
            </a:r>
          </a:p>
        </p:txBody>
      </p:sp>
      <p:pic>
        <p:nvPicPr>
          <p:cNvPr id="14" name="Immagine 13" descr="Immagine che contiene testo, schermata, software, Icona del computer&#10;&#10;Il contenuto generato dall&amp;#39;IA potrebbe non essere corretto.">
            <a:extLst>
              <a:ext uri="{FF2B5EF4-FFF2-40B4-BE49-F238E27FC236}">
                <a16:creationId xmlns:a16="http://schemas.microsoft.com/office/drawing/2014/main" id="{117281C3-28A0-72A4-0317-C4C055658E8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6506" t="34270" r="16717" b="25033"/>
          <a:stretch>
            <a:fillRect/>
          </a:stretch>
        </p:blipFill>
        <p:spPr>
          <a:xfrm>
            <a:off x="6510873" y="1353581"/>
            <a:ext cx="1031213" cy="4121745"/>
          </a:xfrm>
          <a:prstGeom prst="rect">
            <a:avLst/>
          </a:prstGeom>
        </p:spPr>
      </p:pic>
      <p:grpSp>
        <p:nvGrpSpPr>
          <p:cNvPr id="24" name="Gruppo 23">
            <a:extLst>
              <a:ext uri="{FF2B5EF4-FFF2-40B4-BE49-F238E27FC236}">
                <a16:creationId xmlns:a16="http://schemas.microsoft.com/office/drawing/2014/main" id="{25D7F530-1899-5FE4-CCA1-BFB6EA65D18D}"/>
              </a:ext>
            </a:extLst>
          </p:cNvPr>
          <p:cNvGrpSpPr/>
          <p:nvPr/>
        </p:nvGrpSpPr>
        <p:grpSpPr>
          <a:xfrm>
            <a:off x="7617795" y="1651076"/>
            <a:ext cx="1540054" cy="3688572"/>
            <a:chOff x="9189420" y="1479626"/>
            <a:chExt cx="1540054" cy="3688572"/>
          </a:xfrm>
        </p:grpSpPr>
        <p:pic>
          <p:nvPicPr>
            <p:cNvPr id="21" name="Immagine 20" descr="Immagine che contiene testo, schermata, Software multimediale,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ADCB6851-C940-0BD6-2295-EDB85CBBA3A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9578" t="33579" r="68480" b="25615"/>
            <a:stretch>
              <a:fillRect/>
            </a:stretch>
          </p:blipFill>
          <p:spPr>
            <a:xfrm>
              <a:off x="9189420" y="1479626"/>
              <a:ext cx="1536191" cy="2144221"/>
            </a:xfrm>
            <a:prstGeom prst="rect">
              <a:avLst/>
            </a:prstGeom>
          </p:spPr>
        </p:pic>
        <p:pic>
          <p:nvPicPr>
            <p:cNvPr id="4" name="Immagine 3" descr="Immagine che contiene bianco e nero, monocromatic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27C1C448-8CFE-A0ED-6969-F190781E10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94" t="4525" r="491" b="4072"/>
            <a:stretch>
              <a:fillRect/>
            </a:stretch>
          </p:blipFill>
          <p:spPr>
            <a:xfrm>
              <a:off x="9189420" y="3154657"/>
              <a:ext cx="1540054" cy="2013541"/>
            </a:xfrm>
            <a:prstGeom prst="rect">
              <a:avLst/>
            </a:prstGeom>
          </p:spPr>
        </p:pic>
        <p:pic>
          <p:nvPicPr>
            <p:cNvPr id="22" name="Immagine 21" descr="Immagine che contiene bianco e nero, monocromatico, schermata, nero&#10;&#10;Il contenuto generato dall&amp;#39;IA potrebbe non essere corretto.">
              <a:extLst>
                <a:ext uri="{FF2B5EF4-FFF2-40B4-BE49-F238E27FC236}">
                  <a16:creationId xmlns:a16="http://schemas.microsoft.com/office/drawing/2014/main" id="{A3A75F80-D6AB-1505-4B21-50C090DA4D2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4760" t="68182" r="2291" b="-33905"/>
            <a:stretch>
              <a:fillRect/>
            </a:stretch>
          </p:blipFill>
          <p:spPr>
            <a:xfrm>
              <a:off x="9189420" y="2442523"/>
              <a:ext cx="1536587" cy="1458106"/>
            </a:xfrm>
            <a:prstGeom prst="rect">
              <a:avLst/>
            </a:prstGeom>
          </p:spPr>
        </p:pic>
      </p:grp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DDE15DF3-E170-F6EF-882C-07EF66C7C83D}"/>
              </a:ext>
            </a:extLst>
          </p:cNvPr>
          <p:cNvSpPr txBox="1"/>
          <p:nvPr/>
        </p:nvSpPr>
        <p:spPr>
          <a:xfrm>
            <a:off x="9155139" y="4423724"/>
            <a:ext cx="175628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LC3A/B 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529FE119-59D2-B7E0-05B5-2FD7A038047C}"/>
              </a:ext>
            </a:extLst>
          </p:cNvPr>
          <p:cNvSpPr txBox="1"/>
          <p:nvPr/>
        </p:nvSpPr>
        <p:spPr>
          <a:xfrm>
            <a:off x="4398860" y="905782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02883FD-328B-F2E5-DF98-14090B215E63}"/>
              </a:ext>
            </a:extLst>
          </p:cNvPr>
          <p:cNvSpPr txBox="1"/>
          <p:nvPr/>
        </p:nvSpPr>
        <p:spPr>
          <a:xfrm>
            <a:off x="3842848" y="935861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B8D25CBD-C913-A32B-9C6C-FC3023484E7F}"/>
              </a:ext>
            </a:extLst>
          </p:cNvPr>
          <p:cNvSpPr txBox="1"/>
          <p:nvPr/>
        </p:nvSpPr>
        <p:spPr>
          <a:xfrm>
            <a:off x="8188808" y="1176493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/>
              <a:t>Sal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81B9C9E4-2581-2723-7260-094D3479AF81}"/>
              </a:ext>
            </a:extLst>
          </p:cNvPr>
          <p:cNvSpPr txBox="1"/>
          <p:nvPr/>
        </p:nvSpPr>
        <p:spPr>
          <a:xfrm>
            <a:off x="7502454" y="1186519"/>
            <a:ext cx="825744" cy="4001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it-IT" sz="1000" dirty="0"/>
              <a:t>SNU-1</a:t>
            </a:r>
            <a:endParaRPr lang="it-IT" dirty="0"/>
          </a:p>
          <a:p>
            <a:pPr algn="ctr"/>
            <a:r>
              <a:rPr lang="it-IT" sz="1000" dirty="0" err="1"/>
              <a:t>Vehicle</a:t>
            </a:r>
            <a:endParaRPr lang="it-IT" sz="1000"/>
          </a:p>
        </p:txBody>
      </p: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2C5A0946-BD03-ACC5-63B8-87588A17BA78}"/>
              </a:ext>
            </a:extLst>
          </p:cNvPr>
          <p:cNvGrpSpPr/>
          <p:nvPr/>
        </p:nvGrpSpPr>
        <p:grpSpPr>
          <a:xfrm>
            <a:off x="3607269" y="1310181"/>
            <a:ext cx="1785421" cy="4364122"/>
            <a:chOff x="5178894" y="1138731"/>
            <a:chExt cx="1785421" cy="4364122"/>
          </a:xfrm>
        </p:grpSpPr>
        <p:pic>
          <p:nvPicPr>
            <p:cNvPr id="23" name="Immagine 22" descr="Immagine che contiene testo, schermata, Software multimediale, computer&#10;&#10;Il contenuto generato dall&amp;#39;IA potrebbe non essere corretto.">
              <a:extLst>
                <a:ext uri="{FF2B5EF4-FFF2-40B4-BE49-F238E27FC236}">
                  <a16:creationId xmlns:a16="http://schemas.microsoft.com/office/drawing/2014/main" id="{5202E772-B975-AC8A-815A-AE3A700CF1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69630" t="37425" r="15422" b="47260"/>
            <a:stretch>
              <a:fillRect/>
            </a:stretch>
          </p:blipFill>
          <p:spPr>
            <a:xfrm>
              <a:off x="5178894" y="3063904"/>
              <a:ext cx="1752336" cy="723270"/>
            </a:xfrm>
            <a:prstGeom prst="rect">
              <a:avLst/>
            </a:prstGeom>
          </p:spPr>
        </p:pic>
        <p:pic>
          <p:nvPicPr>
            <p:cNvPr id="2" name="Immagine 1" descr="Immagine che contiene vestiti, maschera, bianco e nero, schermat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8FDC6A16-5CCA-CF8F-4894-574D9F85101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-166" t="12854" r="-861" b="429"/>
            <a:stretch>
              <a:fillRect/>
            </a:stretch>
          </p:blipFill>
          <p:spPr>
            <a:xfrm>
              <a:off x="5181239" y="1138731"/>
              <a:ext cx="1751352" cy="2023655"/>
            </a:xfrm>
            <a:prstGeom prst="rect">
              <a:avLst/>
            </a:prstGeom>
          </p:spPr>
        </p:pic>
        <p:pic>
          <p:nvPicPr>
            <p:cNvPr id="6" name="Immagine 5" descr="Immagine che contiene schermata, nero, Rettangolo, Fotografia monocromatica&#10;&#10;Il contenuto generato dall&amp;#39;IA potrebbe non essere corretto.">
              <a:extLst>
                <a:ext uri="{FF2B5EF4-FFF2-40B4-BE49-F238E27FC236}">
                  <a16:creationId xmlns:a16="http://schemas.microsoft.com/office/drawing/2014/main" id="{79F473AB-D4E4-3BEB-52BE-5517D421699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4322" t="10847" r="2128" b="42373"/>
            <a:stretch>
              <a:fillRect/>
            </a:stretch>
          </p:blipFill>
          <p:spPr>
            <a:xfrm>
              <a:off x="5187175" y="3787440"/>
              <a:ext cx="1738612" cy="1371272"/>
            </a:xfrm>
            <a:prstGeom prst="rect">
              <a:avLst/>
            </a:prstGeom>
          </p:spPr>
        </p:pic>
        <p:pic>
          <p:nvPicPr>
            <p:cNvPr id="15" name="Immagine 14" descr="Immagine che contiene bianco e nero, nero, monocromatico, arte&#10;&#10;Il contenuto generato dall&amp;#39;IA potrebbe non essere corretto.">
              <a:extLst>
                <a:ext uri="{FF2B5EF4-FFF2-40B4-BE49-F238E27FC236}">
                  <a16:creationId xmlns:a16="http://schemas.microsoft.com/office/drawing/2014/main" id="{EF68D1D2-A507-05E3-1CA5-E8F740EEEED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13502" t="62888" r="11814" b="6298"/>
            <a:stretch>
              <a:fillRect/>
            </a:stretch>
          </p:blipFill>
          <p:spPr>
            <a:xfrm>
              <a:off x="5187174" y="4528186"/>
              <a:ext cx="1777141" cy="974667"/>
            </a:xfrm>
            <a:prstGeom prst="rect">
              <a:avLst/>
            </a:prstGeom>
          </p:spPr>
        </p:pic>
      </p:grp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AC94A9FD-9E87-0D4F-D281-DD025694D050}"/>
              </a:ext>
            </a:extLst>
          </p:cNvPr>
          <p:cNvSpPr txBox="1"/>
          <p:nvPr/>
        </p:nvSpPr>
        <p:spPr>
          <a:xfrm>
            <a:off x="9157016" y="2843765"/>
            <a:ext cx="150551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it-IT" dirty="0"/>
              <a:t>SQSTM1/p62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81D9DC5-6D70-99A2-07A4-C51B387C59B8}"/>
              </a:ext>
            </a:extLst>
          </p:cNvPr>
          <p:cNvSpPr txBox="1"/>
          <p:nvPr/>
        </p:nvSpPr>
        <p:spPr>
          <a:xfrm>
            <a:off x="6152983" y="5475326"/>
            <a:ext cx="1476261" cy="78864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Protein MW Marker,</a:t>
            </a:r>
            <a:endParaRPr lang="it-IT" dirty="0"/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 Ladder, </a:t>
            </a:r>
            <a:r>
              <a:rPr lang="en-US" sz="1100" dirty="0" err="1">
                <a:solidFill>
                  <a:srgbClr val="333333"/>
                </a:solidFill>
                <a:latin typeface="Aptos"/>
              </a:rPr>
              <a:t>Prestained</a:t>
            </a:r>
            <a:r>
              <a:rPr lang="en-US" sz="1100" dirty="0">
                <a:solidFill>
                  <a:srgbClr val="333333"/>
                </a:solidFill>
                <a:latin typeface="Aptos"/>
              </a:rPr>
              <a:t>, </a:t>
            </a:r>
            <a:endParaRPr lang="en-US" dirty="0">
              <a:solidFill>
                <a:srgbClr val="000000"/>
              </a:solidFill>
              <a:latin typeface="Aptos"/>
            </a:endParaRPr>
          </a:p>
          <a:p>
            <a:r>
              <a:rPr lang="en-US" sz="1100" dirty="0">
                <a:solidFill>
                  <a:srgbClr val="333333"/>
                </a:solidFill>
                <a:latin typeface="Aptos"/>
              </a:rPr>
              <a:t>10-170kD Mark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37729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6FFE3A48493E284283D53EEAEA592EBD" ma:contentTypeVersion="19" ma:contentTypeDescription="Creare un nuovo documento." ma:contentTypeScope="" ma:versionID="2ad6b06b7c82cc53176c08fcaba15c4f">
  <xsd:schema xmlns:xsd="http://www.w3.org/2001/XMLSchema" xmlns:xs="http://www.w3.org/2001/XMLSchema" xmlns:p="http://schemas.microsoft.com/office/2006/metadata/properties" xmlns:ns2="4d249226-1ebe-4684-8b5b-e58e03f2c9a2" xmlns:ns3="58bbee2a-1c83-4eb0-8906-dea3dd29bc78" targetNamespace="http://schemas.microsoft.com/office/2006/metadata/properties" ma:root="true" ma:fieldsID="e0e00a6c99d7b89b4bfa4d7f105f66c8" ns2:_="" ns3:_="">
    <xsd:import namespace="4d249226-1ebe-4684-8b5b-e58e03f2c9a2"/>
    <xsd:import namespace="58bbee2a-1c83-4eb0-8906-dea3dd29bc7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Locatio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2:MediaServiceSearchProperties" minOccurs="0"/>
                <xsd:element ref="ns2:MediaServiceObjectDetectorVersion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d249226-1ebe-4684-8b5b-e58e03f2c9a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GenerationTime" ma:index="1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Tag immagine" ma:readOnly="false" ma:fieldId="{5cf76f15-5ced-4ddc-b409-7134ff3c332f}" ma:taxonomyMulti="true" ma:sspId="becefcd5-cc8e-461c-ac40-04f146a7f01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BillingMetadata" ma:index="25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8bbee2a-1c83-4eb0-8906-dea3dd29bc78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TaxCatchAll" ma:index="21" nillable="true" ma:displayName="Taxonomy Catch All Column" ma:hidden="true" ma:list="{1f472932-f62c-46de-bcef-d0a1639c05db}" ma:internalName="TaxCatchAll" ma:showField="CatchAllData" ma:web="58bbee2a-1c83-4eb0-8906-dea3dd29bc7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4d249226-1ebe-4684-8b5b-e58e03f2c9a2">
      <Terms xmlns="http://schemas.microsoft.com/office/infopath/2007/PartnerControls"/>
    </lcf76f155ced4ddcb4097134ff3c332f>
    <TaxCatchAll xmlns="58bbee2a-1c83-4eb0-8906-dea3dd29bc78" xsi:nil="true"/>
  </documentManagement>
</p:properties>
</file>

<file path=customXml/itemProps1.xml><?xml version="1.0" encoding="utf-8"?>
<ds:datastoreItem xmlns:ds="http://schemas.openxmlformats.org/officeDocument/2006/customXml" ds:itemID="{72958464-CB8F-4076-9C9C-B1EA4599C52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2EC8EAF-7DA6-485B-A92B-32739BE3BA24}">
  <ds:schemaRefs>
    <ds:schemaRef ds:uri="4d249226-1ebe-4684-8b5b-e58e03f2c9a2"/>
    <ds:schemaRef ds:uri="58bbee2a-1c83-4eb0-8906-dea3dd29bc78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7A380A4B-7829-40BC-B2C5-5298178A867A}">
  <ds:schemaRefs>
    <ds:schemaRef ds:uri="58bbee2a-1c83-4eb0-8906-dea3dd29bc78"/>
    <ds:schemaRef ds:uri="4d249226-1ebe-4684-8b5b-e58e03f2c9a2"/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574</Words>
  <Application>Microsoft Office PowerPoint</Application>
  <PresentationFormat>Widescreen</PresentationFormat>
  <Paragraphs>354</Paragraphs>
  <Slides>20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0</vt:i4>
      </vt:variant>
    </vt:vector>
  </HeadingPairs>
  <TitlesOfParts>
    <vt:vector size="24" baseType="lpstr">
      <vt:lpstr>Aptos</vt:lpstr>
      <vt:lpstr>Aptos Display</vt:lpstr>
      <vt:lpstr>Aria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gherita Luongo</dc:creator>
  <cp:lastModifiedBy>Sabino Russi</cp:lastModifiedBy>
  <cp:revision>957</cp:revision>
  <dcterms:created xsi:type="dcterms:W3CDTF">2025-09-09T13:11:42Z</dcterms:created>
  <dcterms:modified xsi:type="dcterms:W3CDTF">2026-01-12T10:47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FE3A48493E284283D53EEAEA592EBD</vt:lpwstr>
  </property>
  <property fmtid="{D5CDD505-2E9C-101B-9397-08002B2CF9AE}" pid="3" name="MediaServiceImageTags">
    <vt:lpwstr/>
  </property>
</Properties>
</file>